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8" r:id="rId2"/>
  </p:sldIdLst>
  <p:sldSz cx="9144000" cy="6858000" type="letter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876"/>
    <a:srgbClr val="990000"/>
    <a:srgbClr val="E6E6E6"/>
    <a:srgbClr val="006A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F07DA55-F6A7-47F5-95D4-864F257BC4CA}" v="176" dt="2022-10-05T14:02:01.048"/>
    <p1510:client id="{BDFC1B8A-C8B8-4665-8988-6B4AA4AE585B}" v="19" dt="2022-10-05T03:36:45.46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98" autoAdjust="0"/>
    <p:restoredTop sz="94633"/>
  </p:normalViewPr>
  <p:slideViewPr>
    <p:cSldViewPr>
      <p:cViewPr varScale="1">
        <p:scale>
          <a:sx n="83" d="100"/>
          <a:sy n="83" d="100"/>
        </p:scale>
        <p:origin x="552" y="90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69424"/>
          </a:xfrm>
          <a:prstGeom prst="rect">
            <a:avLst/>
          </a:prstGeom>
        </p:spPr>
        <p:txBody>
          <a:bodyPr vert="horz" lIns="94225" tIns="47113" rIns="94225" bIns="47113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69424"/>
          </a:xfrm>
          <a:prstGeom prst="rect">
            <a:avLst/>
          </a:prstGeom>
        </p:spPr>
        <p:txBody>
          <a:bodyPr vert="horz" lIns="94225" tIns="47113" rIns="94225" bIns="47113" rtlCol="0"/>
          <a:lstStyle>
            <a:lvl1pPr algn="r">
              <a:defRPr sz="1300"/>
            </a:lvl1pPr>
          </a:lstStyle>
          <a:p>
            <a:fld id="{AAD63468-D4D9-43CA-9ED7-B679E1202D1D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4913" y="704850"/>
            <a:ext cx="4692650" cy="3521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5" tIns="47113" rIns="94225" bIns="4711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459526"/>
            <a:ext cx="5681980" cy="4224814"/>
          </a:xfrm>
          <a:prstGeom prst="rect">
            <a:avLst/>
          </a:prstGeom>
        </p:spPr>
        <p:txBody>
          <a:bodyPr vert="horz" lIns="94225" tIns="47113" rIns="94225" bIns="4711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2"/>
            <a:ext cx="3077739" cy="469424"/>
          </a:xfrm>
          <a:prstGeom prst="rect">
            <a:avLst/>
          </a:prstGeom>
        </p:spPr>
        <p:txBody>
          <a:bodyPr vert="horz" lIns="94225" tIns="47113" rIns="94225" bIns="47113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917422"/>
            <a:ext cx="3077739" cy="469424"/>
          </a:xfrm>
          <a:prstGeom prst="rect">
            <a:avLst/>
          </a:prstGeom>
        </p:spPr>
        <p:txBody>
          <a:bodyPr vert="horz" lIns="94225" tIns="47113" rIns="94225" bIns="47113" rtlCol="0" anchor="b"/>
          <a:lstStyle>
            <a:lvl1pPr algn="r">
              <a:defRPr sz="1300"/>
            </a:lvl1pPr>
          </a:lstStyle>
          <a:p>
            <a:fld id="{6AC2B113-368A-4348-95F3-5083720A03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61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4913" y="704850"/>
            <a:ext cx="4692650" cy="35210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50C957-9DB9-4E3A-9E84-55AEBC4DE0A3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8238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9441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77496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7941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1211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914250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8942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91040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08582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3825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6250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9465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12D55-24BA-42DA-9338-51ACE73BD64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0/6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FCCD8-EE7A-4A39-88B1-DC2D6AF35CFE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7081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-15486" y="1752600"/>
            <a:ext cx="9168346" cy="4648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457200"/>
            <a:ext cx="9144000" cy="1447798"/>
          </a:xfrm>
        </p:spPr>
        <p:txBody>
          <a:bodyPr>
            <a:noAutofit/>
          </a:bodyPr>
          <a:lstStyle/>
          <a:p>
            <a:r>
              <a:rPr lang="en-US" sz="3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oluntary activation of the diaphragm after inspiratory pressure threshold loading</a:t>
            </a:r>
          </a:p>
        </p:txBody>
      </p:sp>
      <p:sp>
        <p:nvSpPr>
          <p:cNvPr id="6" name="Rectangle 5"/>
          <p:cNvSpPr/>
          <p:nvPr/>
        </p:nvSpPr>
        <p:spPr>
          <a:xfrm>
            <a:off x="-15486" y="1905001"/>
            <a:ext cx="9168346" cy="4343400"/>
          </a:xfrm>
          <a:prstGeom prst="rect">
            <a:avLst/>
          </a:prstGeom>
          <a:solidFill>
            <a:schemeClr val="bg1">
              <a:lumMod val="95000"/>
              <a:alpha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4B8B158-39BC-2D4E-9D8C-DD47856BA55F}"/>
              </a:ext>
            </a:extLst>
          </p:cNvPr>
          <p:cNvSpPr/>
          <p:nvPr/>
        </p:nvSpPr>
        <p:spPr>
          <a:xfrm>
            <a:off x="52618" y="1994978"/>
            <a:ext cx="3231978" cy="416067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-1" y="1960285"/>
            <a:ext cx="327966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br>
              <a:rPr lang="en-US" sz="23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400" i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354624" y="4572002"/>
            <a:ext cx="5713177" cy="1583647"/>
          </a:xfrm>
          <a:prstGeom prst="rect">
            <a:avLst/>
          </a:prstGeom>
          <a:solidFill>
            <a:schemeClr val="bg1">
              <a:alpha val="54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8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es show a greater loss in diaphragm contractile function but a similar loss in voluntary activation of the diaphragm compared to females after isolated inspiratory muscle work. </a:t>
            </a:r>
            <a:endParaRPr lang="en-US" sz="14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A559728-7647-ADE8-E18D-04D6F865B090}"/>
              </a:ext>
            </a:extLst>
          </p:cNvPr>
          <p:cNvSpPr/>
          <p:nvPr/>
        </p:nvSpPr>
        <p:spPr bwMode="auto">
          <a:xfrm>
            <a:off x="2514600" y="4902048"/>
            <a:ext cx="209504" cy="203097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20" name="Freeform: Shape 19">
            <a:extLst>
              <a:ext uri="{FF2B5EF4-FFF2-40B4-BE49-F238E27FC236}">
                <a16:creationId xmlns:a16="http://schemas.microsoft.com/office/drawing/2014/main" id="{90CC26E4-6499-504A-C335-C6ABF33CEBA4}"/>
              </a:ext>
            </a:extLst>
          </p:cNvPr>
          <p:cNvSpPr/>
          <p:nvPr/>
        </p:nvSpPr>
        <p:spPr>
          <a:xfrm>
            <a:off x="4204803" y="3467100"/>
            <a:ext cx="7628" cy="30956"/>
          </a:xfrm>
          <a:custGeom>
            <a:avLst/>
            <a:gdLst>
              <a:gd name="connsiteX0" fmla="*/ 7628 w 7628"/>
              <a:gd name="connsiteY0" fmla="*/ 0 h 30956"/>
              <a:gd name="connsiteX1" fmla="*/ 485 w 7628"/>
              <a:gd name="connsiteY1" fmla="*/ 30956 h 309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7628" h="30956">
                <a:moveTo>
                  <a:pt x="7628" y="0"/>
                </a:moveTo>
                <a:cubicBezTo>
                  <a:pt x="-2782" y="17351"/>
                  <a:pt x="485" y="7278"/>
                  <a:pt x="485" y="30956"/>
                </a:cubicBezTo>
              </a:path>
            </a:pathLst>
          </a:cu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Freeform: Shape 20">
            <a:extLst>
              <a:ext uri="{FF2B5EF4-FFF2-40B4-BE49-F238E27FC236}">
                <a16:creationId xmlns:a16="http://schemas.microsoft.com/office/drawing/2014/main" id="{09F7D92E-D368-A268-7A0B-A73921C8C7CE}"/>
              </a:ext>
            </a:extLst>
          </p:cNvPr>
          <p:cNvSpPr/>
          <p:nvPr/>
        </p:nvSpPr>
        <p:spPr>
          <a:xfrm>
            <a:off x="4166712" y="3464719"/>
            <a:ext cx="65921" cy="73819"/>
          </a:xfrm>
          <a:custGeom>
            <a:avLst/>
            <a:gdLst>
              <a:gd name="connsiteX0" fmla="*/ 2381 w 2381"/>
              <a:gd name="connsiteY0" fmla="*/ 0 h 73819"/>
              <a:gd name="connsiteX1" fmla="*/ 0 w 2381"/>
              <a:gd name="connsiteY1" fmla="*/ 73819 h 73819"/>
              <a:gd name="connsiteX2" fmla="*/ 2381 w 2381"/>
              <a:gd name="connsiteY2" fmla="*/ 0 h 738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381" h="73819">
                <a:moveTo>
                  <a:pt x="2381" y="0"/>
                </a:moveTo>
                <a:lnTo>
                  <a:pt x="0" y="73819"/>
                </a:lnTo>
                <a:cubicBezTo>
                  <a:pt x="794" y="54769"/>
                  <a:pt x="2381" y="0"/>
                  <a:pt x="2381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Picture 21" descr="A picture containing icon&#10;&#10;Description automatically generated">
            <a:extLst>
              <a:ext uri="{FF2B5EF4-FFF2-40B4-BE49-F238E27FC236}">
                <a16:creationId xmlns:a16="http://schemas.microsoft.com/office/drawing/2014/main" id="{8E47D184-864B-6234-137A-3501C01360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999" y="2359678"/>
            <a:ext cx="168432" cy="60960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D6C09EAF-6A68-C86D-8A8C-BD4473ACE554}"/>
              </a:ext>
            </a:extLst>
          </p:cNvPr>
          <p:cNvSpPr/>
          <p:nvPr/>
        </p:nvSpPr>
        <p:spPr bwMode="auto">
          <a:xfrm>
            <a:off x="607742" y="4902048"/>
            <a:ext cx="209504" cy="203097"/>
          </a:xfrm>
          <a:prstGeom prst="rect">
            <a:avLst/>
          </a:prstGeom>
          <a:noFill/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174B46C-B24E-71D0-B67E-ACC91E030E6B}"/>
              </a:ext>
            </a:extLst>
          </p:cNvPr>
          <p:cNvSpPr/>
          <p:nvPr/>
        </p:nvSpPr>
        <p:spPr>
          <a:xfrm>
            <a:off x="3354624" y="1994977"/>
            <a:ext cx="5713176" cy="24812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302B0AE-66BC-46EC-E8DD-D0A28EB2416D}"/>
              </a:ext>
            </a:extLst>
          </p:cNvPr>
          <p:cNvSpPr txBox="1"/>
          <p:nvPr/>
        </p:nvSpPr>
        <p:spPr>
          <a:xfrm>
            <a:off x="7410775" y="2057399"/>
            <a:ext cx="1667126" cy="2331244"/>
          </a:xfrm>
          <a:prstGeom prst="rect">
            <a:avLst/>
          </a:prstGeom>
          <a:noFill/>
        </p:spPr>
        <p:txBody>
          <a:bodyPr wrap="square" lIns="91440" tIns="91440" bIns="91440" rtlCol="0">
            <a:noAutofit/>
          </a:bodyPr>
          <a:lstStyle/>
          <a:p>
            <a:r>
              <a:rPr lang="en-US" sz="110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contractile function, measured as transdiaphragmatic twitch pressure (P</a:t>
            </a:r>
            <a:r>
              <a:rPr lang="en-US" sz="1100" baseline="-2500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,TW</a:t>
            </a:r>
            <a:r>
              <a:rPr lang="en-US" sz="110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after inspiratory pressure threshold loading (</a:t>
            </a:r>
            <a:r>
              <a:rPr lang="en-US" sz="1100" b="1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en-US" sz="1100" dirty="0">
              <a:solidFill>
                <a:srgbClr val="00387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diaphragm voluntary activation after inspiratory pressure threshold loading (</a:t>
            </a:r>
            <a:r>
              <a:rPr lang="en-US" sz="1100" b="1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100" dirty="0">
              <a:solidFill>
                <a:srgbClr val="00387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6B02A61-1719-C08D-9FCB-5FA9EC18FF5B}"/>
              </a:ext>
            </a:extLst>
          </p:cNvPr>
          <p:cNvSpPr txBox="1"/>
          <p:nvPr/>
        </p:nvSpPr>
        <p:spPr>
          <a:xfrm>
            <a:off x="4568934" y="1960285"/>
            <a:ext cx="327966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br>
              <a:rPr lang="en-US" sz="23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1400" i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2D00280F-5173-65A1-5B0C-0A0BFD0CC21A}"/>
              </a:ext>
            </a:extLst>
          </p:cNvPr>
          <p:cNvGrpSpPr/>
          <p:nvPr/>
        </p:nvGrpSpPr>
        <p:grpSpPr>
          <a:xfrm>
            <a:off x="228600" y="3438525"/>
            <a:ext cx="2908537" cy="1918751"/>
            <a:chOff x="-1519430" y="2324100"/>
            <a:chExt cx="4395468" cy="2899677"/>
          </a:xfrm>
        </p:grpSpPr>
        <p:pic>
          <p:nvPicPr>
            <p:cNvPr id="13" name="Picture 12" descr="Diagram&#10;&#10;Description automatically generated">
              <a:extLst>
                <a:ext uri="{FF2B5EF4-FFF2-40B4-BE49-F238E27FC236}">
                  <a16:creationId xmlns:a16="http://schemas.microsoft.com/office/drawing/2014/main" id="{D655A211-C400-F5ED-262E-8DC26214E5E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02731" y="3783777"/>
              <a:ext cx="1440000" cy="1440000"/>
            </a:xfrm>
            <a:prstGeom prst="rect">
              <a:avLst/>
            </a:prstGeom>
          </p:spPr>
        </p:pic>
        <p:pic>
          <p:nvPicPr>
            <p:cNvPr id="14" name="Picture 13" descr="Diagram&#10;&#10;Description automatically generated">
              <a:extLst>
                <a:ext uri="{FF2B5EF4-FFF2-40B4-BE49-F238E27FC236}">
                  <a16:creationId xmlns:a16="http://schemas.microsoft.com/office/drawing/2014/main" id="{19E2B504-5016-4365-476A-5BA43DCC3E5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03623" y="3783777"/>
              <a:ext cx="1440000" cy="1440000"/>
            </a:xfrm>
            <a:prstGeom prst="rect">
              <a:avLst/>
            </a:prstGeom>
          </p:spPr>
        </p:pic>
        <p:pic>
          <p:nvPicPr>
            <p:cNvPr id="15" name="Picture 14" descr="Chart, line chart&#10;&#10;Description automatically generated">
              <a:extLst>
                <a:ext uri="{FF2B5EF4-FFF2-40B4-BE49-F238E27FC236}">
                  <a16:creationId xmlns:a16="http://schemas.microsoft.com/office/drawing/2014/main" id="{8E932B46-82A0-B3CD-F77B-6CCDDD36930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519430" y="3783777"/>
              <a:ext cx="1440000" cy="1440000"/>
            </a:xfrm>
            <a:prstGeom prst="rect">
              <a:avLst/>
            </a:prstGeom>
          </p:spPr>
        </p:pic>
        <p:pic>
          <p:nvPicPr>
            <p:cNvPr id="19" name="Picture 18" descr="Chart, histogram&#10;&#10;Description automatically generated">
              <a:extLst>
                <a:ext uri="{FF2B5EF4-FFF2-40B4-BE49-F238E27FC236}">
                  <a16:creationId xmlns:a16="http://schemas.microsoft.com/office/drawing/2014/main" id="{A98E48EF-7735-06E6-1269-4C1D18717EB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83681" y="2341631"/>
              <a:ext cx="1440000" cy="1440000"/>
            </a:xfrm>
            <a:prstGeom prst="rect">
              <a:avLst/>
            </a:prstGeom>
          </p:spPr>
        </p:pic>
        <p:pic>
          <p:nvPicPr>
            <p:cNvPr id="23" name="Picture 22" descr="Chart, line chart, histogram&#10;&#10;Description automatically generated">
              <a:extLst>
                <a:ext uri="{FF2B5EF4-FFF2-40B4-BE49-F238E27FC236}">
                  <a16:creationId xmlns:a16="http://schemas.microsoft.com/office/drawing/2014/main" id="{2D2E13FF-1CFA-38F3-D9A1-375652603D1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5848" y="2341631"/>
              <a:ext cx="1440000" cy="1440000"/>
            </a:xfrm>
            <a:prstGeom prst="rect">
              <a:avLst/>
            </a:prstGeom>
          </p:spPr>
        </p:pic>
        <p:pic>
          <p:nvPicPr>
            <p:cNvPr id="25" name="Picture 24" descr="Chart&#10;&#10;Description automatically generated">
              <a:extLst>
                <a:ext uri="{FF2B5EF4-FFF2-40B4-BE49-F238E27FC236}">
                  <a16:creationId xmlns:a16="http://schemas.microsoft.com/office/drawing/2014/main" id="{2E095CCE-28AF-FD88-2126-13E859B5374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498001" y="2341631"/>
              <a:ext cx="1440000" cy="1440000"/>
            </a:xfrm>
            <a:prstGeom prst="rect">
              <a:avLst/>
            </a:prstGeom>
          </p:spPr>
        </p:pic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77BE7B1A-E7BE-35BC-BF39-6B370696B5E9}"/>
                </a:ext>
              </a:extLst>
            </p:cNvPr>
            <p:cNvSpPr/>
            <p:nvPr/>
          </p:nvSpPr>
          <p:spPr>
            <a:xfrm>
              <a:off x="-76201" y="2362200"/>
              <a:ext cx="396424" cy="1295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B9E8CCD3-E38B-E1C4-595E-C329BE20B174}"/>
                </a:ext>
              </a:extLst>
            </p:cNvPr>
            <p:cNvSpPr/>
            <p:nvPr/>
          </p:nvSpPr>
          <p:spPr>
            <a:xfrm>
              <a:off x="1291273" y="2324100"/>
              <a:ext cx="432544" cy="1295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A5524BC7-A073-36FD-4EAD-A74197B64FB7}"/>
                </a:ext>
              </a:extLst>
            </p:cNvPr>
            <p:cNvSpPr/>
            <p:nvPr/>
          </p:nvSpPr>
          <p:spPr>
            <a:xfrm rot="5400000">
              <a:off x="706407" y="1665612"/>
              <a:ext cx="396424" cy="394283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C79AC220-282E-0CBD-0FB6-37AE081DA860}"/>
                </a:ext>
              </a:extLst>
            </p:cNvPr>
            <p:cNvSpPr/>
            <p:nvPr/>
          </p:nvSpPr>
          <p:spPr>
            <a:xfrm>
              <a:off x="-1143000" y="3505200"/>
              <a:ext cx="152400" cy="1143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77A9D505-9F71-6D98-7560-D71FBD7FB62A}"/>
                </a:ext>
              </a:extLst>
            </p:cNvPr>
            <p:cNvSpPr/>
            <p:nvPr/>
          </p:nvSpPr>
          <p:spPr>
            <a:xfrm>
              <a:off x="-1082337" y="3429001"/>
              <a:ext cx="152400" cy="114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39BABBD3-4E8A-6D24-FE4B-16ABD7B7F157}"/>
                </a:ext>
              </a:extLst>
            </p:cNvPr>
            <p:cNvSpPr/>
            <p:nvPr/>
          </p:nvSpPr>
          <p:spPr>
            <a:xfrm>
              <a:off x="-1133474" y="3461148"/>
              <a:ext cx="152400" cy="1143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67F3748-DB9B-D970-4C75-790F6F517D38}"/>
                </a:ext>
              </a:extLst>
            </p:cNvPr>
            <p:cNvSpPr/>
            <p:nvPr/>
          </p:nvSpPr>
          <p:spPr>
            <a:xfrm>
              <a:off x="-102731" y="3733800"/>
              <a:ext cx="407531" cy="1219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DCEDFEA7-7ACC-973D-0C03-1BC6F5077265}"/>
                </a:ext>
              </a:extLst>
            </p:cNvPr>
            <p:cNvSpPr/>
            <p:nvPr/>
          </p:nvSpPr>
          <p:spPr>
            <a:xfrm>
              <a:off x="-84012" y="3676654"/>
              <a:ext cx="407530" cy="1219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54079446-D1D4-0D71-348A-EE0D8B708754}"/>
                </a:ext>
              </a:extLst>
            </p:cNvPr>
            <p:cNvSpPr/>
            <p:nvPr/>
          </p:nvSpPr>
          <p:spPr>
            <a:xfrm>
              <a:off x="1284732" y="3674673"/>
              <a:ext cx="443576" cy="1219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BD621526-745B-F1F8-B577-0286FB7BF374}"/>
                </a:ext>
              </a:extLst>
            </p:cNvPr>
            <p:cNvSpPr/>
            <p:nvPr/>
          </p:nvSpPr>
          <p:spPr>
            <a:xfrm>
              <a:off x="1560913" y="4876800"/>
              <a:ext cx="152400" cy="76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EBE476FB-AFD0-C628-D056-4F63620CFF9B}"/>
              </a:ext>
            </a:extLst>
          </p:cNvPr>
          <p:cNvSpPr txBox="1"/>
          <p:nvPr/>
        </p:nvSpPr>
        <p:spPr>
          <a:xfrm>
            <a:off x="1421443" y="4200722"/>
            <a:ext cx="649224" cy="274320"/>
          </a:xfrm>
          <a:prstGeom prst="rect">
            <a:avLst/>
          </a:prstGeom>
          <a:noFill/>
        </p:spPr>
        <p:txBody>
          <a:bodyPr wrap="none" rtlCol="0" anchor="ctr" anchorCtr="0">
            <a:no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irst minut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524EAF1-5F97-0DEF-0F0C-779658161948}"/>
              </a:ext>
            </a:extLst>
          </p:cNvPr>
          <p:cNvSpPr txBox="1"/>
          <p:nvPr/>
        </p:nvSpPr>
        <p:spPr>
          <a:xfrm>
            <a:off x="2371496" y="4200722"/>
            <a:ext cx="618292" cy="274320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Task failure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8E94133-BFC3-CBB4-2C35-201AE4D821E6}"/>
              </a:ext>
            </a:extLst>
          </p:cNvPr>
          <p:cNvSpPr txBox="1"/>
          <p:nvPr/>
        </p:nvSpPr>
        <p:spPr>
          <a:xfrm>
            <a:off x="507775" y="4203152"/>
            <a:ext cx="649224" cy="269460"/>
          </a:xfrm>
          <a:prstGeom prst="rect">
            <a:avLst/>
          </a:prstGeom>
          <a:noFill/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5D4B9369-8EF0-75D0-52C5-8575C0F93FC9}"/>
              </a:ext>
            </a:extLst>
          </p:cNvPr>
          <p:cNvGrpSpPr/>
          <p:nvPr/>
        </p:nvGrpSpPr>
        <p:grpSpPr>
          <a:xfrm>
            <a:off x="61906" y="2281060"/>
            <a:ext cx="775317" cy="769281"/>
            <a:chOff x="-647946" y="2660840"/>
            <a:chExt cx="4966505" cy="2276863"/>
          </a:xfrm>
        </p:grpSpPr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95F5D6E1-B9D5-FEE8-1095-F4C972988EDF}"/>
                </a:ext>
              </a:extLst>
            </p:cNvPr>
            <p:cNvGrpSpPr/>
            <p:nvPr/>
          </p:nvGrpSpPr>
          <p:grpSpPr>
            <a:xfrm>
              <a:off x="935278" y="2660840"/>
              <a:ext cx="3383281" cy="1752331"/>
              <a:chOff x="1493520" y="1722120"/>
              <a:chExt cx="6797040" cy="3520440"/>
            </a:xfrm>
          </p:grpSpPr>
          <p:sp>
            <p:nvSpPr>
              <p:cNvPr id="83" name="Freeform 27">
                <a:extLst>
                  <a:ext uri="{FF2B5EF4-FFF2-40B4-BE49-F238E27FC236}">
                    <a16:creationId xmlns:a16="http://schemas.microsoft.com/office/drawing/2014/main" id="{44121009-3640-0D37-59B3-4E4FECD5500D}"/>
                  </a:ext>
                </a:extLst>
              </p:cNvPr>
              <p:cNvSpPr/>
              <p:nvPr/>
            </p:nvSpPr>
            <p:spPr>
              <a:xfrm>
                <a:off x="3658894" y="2645766"/>
                <a:ext cx="627514" cy="305855"/>
              </a:xfrm>
              <a:custGeom>
                <a:avLst/>
                <a:gdLst>
                  <a:gd name="connsiteX0" fmla="*/ 0 w 2628053"/>
                  <a:gd name="connsiteY0" fmla="*/ 3294787 h 3665894"/>
                  <a:gd name="connsiteX1" fmla="*/ 778933 w 2628053"/>
                  <a:gd name="connsiteY1" fmla="*/ 3389613 h 3665894"/>
                  <a:gd name="connsiteX2" fmla="*/ 1144693 w 2628053"/>
                  <a:gd name="connsiteY2" fmla="*/ 212920 h 3665894"/>
                  <a:gd name="connsiteX3" fmla="*/ 1320800 w 2628053"/>
                  <a:gd name="connsiteY3" fmla="*/ 422893 h 3665894"/>
                  <a:gd name="connsiteX4" fmla="*/ 1490133 w 2628053"/>
                  <a:gd name="connsiteY4" fmla="*/ 1479533 h 3665894"/>
                  <a:gd name="connsiteX5" fmla="*/ 1551093 w 2628053"/>
                  <a:gd name="connsiteY5" fmla="*/ 1764013 h 3665894"/>
                  <a:gd name="connsiteX6" fmla="*/ 2255520 w 2628053"/>
                  <a:gd name="connsiteY6" fmla="*/ 3172867 h 3665894"/>
                  <a:gd name="connsiteX7" fmla="*/ 2628053 w 2628053"/>
                  <a:gd name="connsiteY7" fmla="*/ 3260920 h 3665894"/>
                  <a:gd name="connsiteX0" fmla="*/ 0 w 2628053"/>
                  <a:gd name="connsiteY0" fmla="*/ 3294787 h 3604646"/>
                  <a:gd name="connsiteX1" fmla="*/ 494453 w 2628053"/>
                  <a:gd name="connsiteY1" fmla="*/ 3315107 h 3604646"/>
                  <a:gd name="connsiteX2" fmla="*/ 778933 w 2628053"/>
                  <a:gd name="connsiteY2" fmla="*/ 3389613 h 3604646"/>
                  <a:gd name="connsiteX3" fmla="*/ 1144693 w 2628053"/>
                  <a:gd name="connsiteY3" fmla="*/ 212920 h 3604646"/>
                  <a:gd name="connsiteX4" fmla="*/ 1320800 w 2628053"/>
                  <a:gd name="connsiteY4" fmla="*/ 422893 h 3604646"/>
                  <a:gd name="connsiteX5" fmla="*/ 1490133 w 2628053"/>
                  <a:gd name="connsiteY5" fmla="*/ 1479533 h 3604646"/>
                  <a:gd name="connsiteX6" fmla="*/ 1551093 w 2628053"/>
                  <a:gd name="connsiteY6" fmla="*/ 1764013 h 3604646"/>
                  <a:gd name="connsiteX7" fmla="*/ 2255520 w 2628053"/>
                  <a:gd name="connsiteY7" fmla="*/ 3172867 h 3604646"/>
                  <a:gd name="connsiteX8" fmla="*/ 2628053 w 2628053"/>
                  <a:gd name="connsiteY8" fmla="*/ 3260920 h 3604646"/>
                  <a:gd name="connsiteX0" fmla="*/ 0 w 2628053"/>
                  <a:gd name="connsiteY0" fmla="*/ 3269778 h 3357961"/>
                  <a:gd name="connsiteX1" fmla="*/ 494453 w 2628053"/>
                  <a:gd name="connsiteY1" fmla="*/ 3290098 h 3357961"/>
                  <a:gd name="connsiteX2" fmla="*/ 866986 w 2628053"/>
                  <a:gd name="connsiteY2" fmla="*/ 3025937 h 3357961"/>
                  <a:gd name="connsiteX3" fmla="*/ 1144693 w 2628053"/>
                  <a:gd name="connsiteY3" fmla="*/ 187911 h 3357961"/>
                  <a:gd name="connsiteX4" fmla="*/ 1320800 w 2628053"/>
                  <a:gd name="connsiteY4" fmla="*/ 397884 h 3357961"/>
                  <a:gd name="connsiteX5" fmla="*/ 1490133 w 2628053"/>
                  <a:gd name="connsiteY5" fmla="*/ 1454524 h 3357961"/>
                  <a:gd name="connsiteX6" fmla="*/ 1551093 w 2628053"/>
                  <a:gd name="connsiteY6" fmla="*/ 1739004 h 3357961"/>
                  <a:gd name="connsiteX7" fmla="*/ 2255520 w 2628053"/>
                  <a:gd name="connsiteY7" fmla="*/ 3147858 h 3357961"/>
                  <a:gd name="connsiteX8" fmla="*/ 2628053 w 2628053"/>
                  <a:gd name="connsiteY8" fmla="*/ 3235911 h 3357961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551093 w 2628053"/>
                  <a:gd name="connsiteY6" fmla="*/ 1739004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3535680"/>
                  <a:gd name="connsiteY0" fmla="*/ 3269778 h 3382815"/>
                  <a:gd name="connsiteX1" fmla="*/ 494453 w 3535680"/>
                  <a:gd name="connsiteY1" fmla="*/ 3290098 h 3382815"/>
                  <a:gd name="connsiteX2" fmla="*/ 866986 w 3535680"/>
                  <a:gd name="connsiteY2" fmla="*/ 3025937 h 3382815"/>
                  <a:gd name="connsiteX3" fmla="*/ 1144693 w 3535680"/>
                  <a:gd name="connsiteY3" fmla="*/ 187911 h 3382815"/>
                  <a:gd name="connsiteX4" fmla="*/ 1320800 w 3535680"/>
                  <a:gd name="connsiteY4" fmla="*/ 397884 h 3382815"/>
                  <a:gd name="connsiteX5" fmla="*/ 1490133 w 3535680"/>
                  <a:gd name="connsiteY5" fmla="*/ 1454524 h 3382815"/>
                  <a:gd name="connsiteX6" fmla="*/ 1645919 w 3535680"/>
                  <a:gd name="connsiteY6" fmla="*/ 2097990 h 3382815"/>
                  <a:gd name="connsiteX7" fmla="*/ 2255520 w 3535680"/>
                  <a:gd name="connsiteY7" fmla="*/ 3147858 h 3382815"/>
                  <a:gd name="connsiteX8" fmla="*/ 3535680 w 3535680"/>
                  <a:gd name="connsiteY8" fmla="*/ 3351057 h 3382815"/>
                  <a:gd name="connsiteX0" fmla="*/ 0 w 3535680"/>
                  <a:gd name="connsiteY0" fmla="*/ 3269778 h 3362942"/>
                  <a:gd name="connsiteX1" fmla="*/ 494453 w 3535680"/>
                  <a:gd name="connsiteY1" fmla="*/ 3290098 h 3362942"/>
                  <a:gd name="connsiteX2" fmla="*/ 866986 w 3535680"/>
                  <a:gd name="connsiteY2" fmla="*/ 3025937 h 3362942"/>
                  <a:gd name="connsiteX3" fmla="*/ 1144693 w 3535680"/>
                  <a:gd name="connsiteY3" fmla="*/ 187911 h 3362942"/>
                  <a:gd name="connsiteX4" fmla="*/ 1320800 w 3535680"/>
                  <a:gd name="connsiteY4" fmla="*/ 397884 h 3362942"/>
                  <a:gd name="connsiteX5" fmla="*/ 1490133 w 3535680"/>
                  <a:gd name="connsiteY5" fmla="*/ 1454524 h 3362942"/>
                  <a:gd name="connsiteX6" fmla="*/ 1645919 w 3535680"/>
                  <a:gd name="connsiteY6" fmla="*/ 2097990 h 3362942"/>
                  <a:gd name="connsiteX7" fmla="*/ 2255520 w 3535680"/>
                  <a:gd name="connsiteY7" fmla="*/ 3147858 h 3362942"/>
                  <a:gd name="connsiteX8" fmla="*/ 3535680 w 3535680"/>
                  <a:gd name="connsiteY8" fmla="*/ 3351057 h 3362942"/>
                  <a:gd name="connsiteX0" fmla="*/ 0 w 3535680"/>
                  <a:gd name="connsiteY0" fmla="*/ 3269778 h 3386908"/>
                  <a:gd name="connsiteX1" fmla="*/ 406400 w 3535680"/>
                  <a:gd name="connsiteY1" fmla="*/ 3337512 h 3386908"/>
                  <a:gd name="connsiteX2" fmla="*/ 866986 w 3535680"/>
                  <a:gd name="connsiteY2" fmla="*/ 3025937 h 3386908"/>
                  <a:gd name="connsiteX3" fmla="*/ 1144693 w 3535680"/>
                  <a:gd name="connsiteY3" fmla="*/ 187911 h 3386908"/>
                  <a:gd name="connsiteX4" fmla="*/ 1320800 w 3535680"/>
                  <a:gd name="connsiteY4" fmla="*/ 397884 h 3386908"/>
                  <a:gd name="connsiteX5" fmla="*/ 1490133 w 3535680"/>
                  <a:gd name="connsiteY5" fmla="*/ 1454524 h 3386908"/>
                  <a:gd name="connsiteX6" fmla="*/ 1645919 w 3535680"/>
                  <a:gd name="connsiteY6" fmla="*/ 2097990 h 3386908"/>
                  <a:gd name="connsiteX7" fmla="*/ 2255520 w 3535680"/>
                  <a:gd name="connsiteY7" fmla="*/ 3147858 h 3386908"/>
                  <a:gd name="connsiteX8" fmla="*/ 3535680 w 3535680"/>
                  <a:gd name="connsiteY8" fmla="*/ 3351057 h 3386908"/>
                  <a:gd name="connsiteX0" fmla="*/ 0 w 3535680"/>
                  <a:gd name="connsiteY0" fmla="*/ 3269778 h 3362216"/>
                  <a:gd name="connsiteX1" fmla="*/ 406400 w 3535680"/>
                  <a:gd name="connsiteY1" fmla="*/ 3337512 h 3362216"/>
                  <a:gd name="connsiteX2" fmla="*/ 866986 w 3535680"/>
                  <a:gd name="connsiteY2" fmla="*/ 3025937 h 3362216"/>
                  <a:gd name="connsiteX3" fmla="*/ 1144693 w 3535680"/>
                  <a:gd name="connsiteY3" fmla="*/ 187911 h 3362216"/>
                  <a:gd name="connsiteX4" fmla="*/ 1320800 w 3535680"/>
                  <a:gd name="connsiteY4" fmla="*/ 397884 h 3362216"/>
                  <a:gd name="connsiteX5" fmla="*/ 1490133 w 3535680"/>
                  <a:gd name="connsiteY5" fmla="*/ 1454524 h 3362216"/>
                  <a:gd name="connsiteX6" fmla="*/ 1645919 w 3535680"/>
                  <a:gd name="connsiteY6" fmla="*/ 2097990 h 3362216"/>
                  <a:gd name="connsiteX7" fmla="*/ 2255520 w 3535680"/>
                  <a:gd name="connsiteY7" fmla="*/ 3147858 h 3362216"/>
                  <a:gd name="connsiteX8" fmla="*/ 3535680 w 3535680"/>
                  <a:gd name="connsiteY8" fmla="*/ 3351057 h 33622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535680" h="3362216">
                    <a:moveTo>
                      <a:pt x="0" y="3269778"/>
                    </a:moveTo>
                    <a:cubicBezTo>
                      <a:pt x="83538" y="3330738"/>
                      <a:pt x="276578" y="3321708"/>
                      <a:pt x="406400" y="3337512"/>
                    </a:cubicBezTo>
                    <a:cubicBezTo>
                      <a:pt x="536222" y="3292356"/>
                      <a:pt x="743937" y="3550870"/>
                      <a:pt x="866986" y="3025937"/>
                    </a:cubicBezTo>
                    <a:cubicBezTo>
                      <a:pt x="990035" y="2501004"/>
                      <a:pt x="1069057" y="625920"/>
                      <a:pt x="1144693" y="187911"/>
                    </a:cubicBezTo>
                    <a:cubicBezTo>
                      <a:pt x="1220329" y="-250098"/>
                      <a:pt x="1263227" y="186782"/>
                      <a:pt x="1320800" y="397884"/>
                    </a:cubicBezTo>
                    <a:cubicBezTo>
                      <a:pt x="1378373" y="608986"/>
                      <a:pt x="1435947" y="1171173"/>
                      <a:pt x="1490133" y="1454524"/>
                    </a:cubicBezTo>
                    <a:cubicBezTo>
                      <a:pt x="1544319" y="1737875"/>
                      <a:pt x="1545449" y="1761581"/>
                      <a:pt x="1645919" y="2097990"/>
                    </a:cubicBezTo>
                    <a:cubicBezTo>
                      <a:pt x="1746389" y="2434399"/>
                      <a:pt x="1940560" y="2939014"/>
                      <a:pt x="2255520" y="3147858"/>
                    </a:cubicBezTo>
                    <a:cubicBezTo>
                      <a:pt x="2570480" y="3356702"/>
                      <a:pt x="3337560" y="3377586"/>
                      <a:pt x="3535680" y="3351057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4" name="Freeform 28">
                <a:extLst>
                  <a:ext uri="{FF2B5EF4-FFF2-40B4-BE49-F238E27FC236}">
                    <a16:creationId xmlns:a16="http://schemas.microsoft.com/office/drawing/2014/main" id="{147D9AEC-EF80-63AE-5C2C-85D570CAE863}"/>
                  </a:ext>
                </a:extLst>
              </p:cNvPr>
              <p:cNvSpPr/>
              <p:nvPr/>
            </p:nvSpPr>
            <p:spPr>
              <a:xfrm>
                <a:off x="1822303" y="2937268"/>
                <a:ext cx="1861458" cy="1996493"/>
              </a:xfrm>
              <a:custGeom>
                <a:avLst/>
                <a:gdLst>
                  <a:gd name="connsiteX0" fmla="*/ 1861458 w 1861458"/>
                  <a:gd name="connsiteY0" fmla="*/ 199527 h 2195445"/>
                  <a:gd name="connsiteX1" fmla="*/ 800100 w 1861458"/>
                  <a:gd name="connsiteY1" fmla="*/ 150541 h 2195445"/>
                  <a:gd name="connsiteX2" fmla="*/ 391886 w 1861458"/>
                  <a:gd name="connsiteY2" fmla="*/ 1873205 h 2195445"/>
                  <a:gd name="connsiteX3" fmla="*/ 0 w 1861458"/>
                  <a:gd name="connsiteY3" fmla="*/ 2191612 h 2195445"/>
                  <a:gd name="connsiteX0" fmla="*/ 1861458 w 1861458"/>
                  <a:gd name="connsiteY0" fmla="*/ 44864 h 2038023"/>
                  <a:gd name="connsiteX1" fmla="*/ 644979 w 1861458"/>
                  <a:gd name="connsiteY1" fmla="*/ 477570 h 2038023"/>
                  <a:gd name="connsiteX2" fmla="*/ 391886 w 1861458"/>
                  <a:gd name="connsiteY2" fmla="*/ 1718542 h 2038023"/>
                  <a:gd name="connsiteX3" fmla="*/ 0 w 1861458"/>
                  <a:gd name="connsiteY3" fmla="*/ 2036949 h 2038023"/>
                  <a:gd name="connsiteX0" fmla="*/ 1861458 w 1861458"/>
                  <a:gd name="connsiteY0" fmla="*/ 3334 h 1996493"/>
                  <a:gd name="connsiteX1" fmla="*/ 1004208 w 1861458"/>
                  <a:gd name="connsiteY1" fmla="*/ 35991 h 1996493"/>
                  <a:gd name="connsiteX2" fmla="*/ 644979 w 1861458"/>
                  <a:gd name="connsiteY2" fmla="*/ 436040 h 1996493"/>
                  <a:gd name="connsiteX3" fmla="*/ 391886 w 1861458"/>
                  <a:gd name="connsiteY3" fmla="*/ 1677012 h 1996493"/>
                  <a:gd name="connsiteX4" fmla="*/ 0 w 1861458"/>
                  <a:gd name="connsiteY4" fmla="*/ 1995419 h 19964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61458" h="1996493">
                    <a:moveTo>
                      <a:pt x="1861458" y="3334"/>
                    </a:moveTo>
                    <a:cubicBezTo>
                      <a:pt x="1714501" y="26466"/>
                      <a:pt x="1206955" y="-36127"/>
                      <a:pt x="1004208" y="35991"/>
                    </a:cubicBezTo>
                    <a:cubicBezTo>
                      <a:pt x="801461" y="108109"/>
                      <a:pt x="747033" y="162537"/>
                      <a:pt x="644979" y="436040"/>
                    </a:cubicBezTo>
                    <a:cubicBezTo>
                      <a:pt x="542925" y="709543"/>
                      <a:pt x="499383" y="1417116"/>
                      <a:pt x="391886" y="1677012"/>
                    </a:cubicBezTo>
                    <a:cubicBezTo>
                      <a:pt x="284390" y="1936909"/>
                      <a:pt x="129268" y="2006304"/>
                      <a:pt x="0" y="1995419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5" name="Freeform 29">
                <a:extLst>
                  <a:ext uri="{FF2B5EF4-FFF2-40B4-BE49-F238E27FC236}">
                    <a16:creationId xmlns:a16="http://schemas.microsoft.com/office/drawing/2014/main" id="{7E88DA79-FDAF-D860-249B-9B5B1DA32C69}"/>
                  </a:ext>
                </a:extLst>
              </p:cNvPr>
              <p:cNvSpPr/>
              <p:nvPr/>
            </p:nvSpPr>
            <p:spPr>
              <a:xfrm>
                <a:off x="4225645" y="2954564"/>
                <a:ext cx="1674284" cy="1903411"/>
              </a:xfrm>
              <a:custGeom>
                <a:avLst/>
                <a:gdLst>
                  <a:gd name="connsiteX0" fmla="*/ 0 w 1657350"/>
                  <a:gd name="connsiteY0" fmla="*/ 907 h 1913583"/>
                  <a:gd name="connsiteX1" fmla="*/ 138793 w 1657350"/>
                  <a:gd name="connsiteY1" fmla="*/ 9072 h 1913583"/>
                  <a:gd name="connsiteX2" fmla="*/ 269422 w 1657350"/>
                  <a:gd name="connsiteY2" fmla="*/ 66222 h 1913583"/>
                  <a:gd name="connsiteX3" fmla="*/ 375557 w 1657350"/>
                  <a:gd name="connsiteY3" fmla="*/ 254000 h 1913583"/>
                  <a:gd name="connsiteX4" fmla="*/ 604157 w 1657350"/>
                  <a:gd name="connsiteY4" fmla="*/ 1707243 h 1913583"/>
                  <a:gd name="connsiteX5" fmla="*/ 1657350 w 1657350"/>
                  <a:gd name="connsiteY5" fmla="*/ 1870529 h 1913583"/>
                  <a:gd name="connsiteX0" fmla="*/ 0 w 1674284"/>
                  <a:gd name="connsiteY0" fmla="*/ 907 h 1925546"/>
                  <a:gd name="connsiteX1" fmla="*/ 138793 w 1674284"/>
                  <a:gd name="connsiteY1" fmla="*/ 9072 h 1925546"/>
                  <a:gd name="connsiteX2" fmla="*/ 269422 w 1674284"/>
                  <a:gd name="connsiteY2" fmla="*/ 66222 h 1925546"/>
                  <a:gd name="connsiteX3" fmla="*/ 375557 w 1674284"/>
                  <a:gd name="connsiteY3" fmla="*/ 254000 h 1925546"/>
                  <a:gd name="connsiteX4" fmla="*/ 604157 w 1674284"/>
                  <a:gd name="connsiteY4" fmla="*/ 1707243 h 1925546"/>
                  <a:gd name="connsiteX5" fmla="*/ 1674284 w 1674284"/>
                  <a:gd name="connsiteY5" fmla="*/ 1887462 h 1925546"/>
                  <a:gd name="connsiteX0" fmla="*/ 0 w 1674284"/>
                  <a:gd name="connsiteY0" fmla="*/ 907 h 1903411"/>
                  <a:gd name="connsiteX1" fmla="*/ 138793 w 1674284"/>
                  <a:gd name="connsiteY1" fmla="*/ 9072 h 1903411"/>
                  <a:gd name="connsiteX2" fmla="*/ 269422 w 1674284"/>
                  <a:gd name="connsiteY2" fmla="*/ 66222 h 1903411"/>
                  <a:gd name="connsiteX3" fmla="*/ 375557 w 1674284"/>
                  <a:gd name="connsiteY3" fmla="*/ 254000 h 1903411"/>
                  <a:gd name="connsiteX4" fmla="*/ 604157 w 1674284"/>
                  <a:gd name="connsiteY4" fmla="*/ 1707243 h 1903411"/>
                  <a:gd name="connsiteX5" fmla="*/ 1674284 w 1674284"/>
                  <a:gd name="connsiteY5" fmla="*/ 1887462 h 19034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674284" h="1903411">
                    <a:moveTo>
                      <a:pt x="0" y="907"/>
                    </a:moveTo>
                    <a:cubicBezTo>
                      <a:pt x="46944" y="-454"/>
                      <a:pt x="93889" y="-1814"/>
                      <a:pt x="138793" y="9072"/>
                    </a:cubicBezTo>
                    <a:cubicBezTo>
                      <a:pt x="183697" y="19958"/>
                      <a:pt x="229961" y="25401"/>
                      <a:pt x="269422" y="66222"/>
                    </a:cubicBezTo>
                    <a:cubicBezTo>
                      <a:pt x="308883" y="107043"/>
                      <a:pt x="319768" y="-19504"/>
                      <a:pt x="375557" y="254000"/>
                    </a:cubicBezTo>
                    <a:cubicBezTo>
                      <a:pt x="431346" y="527504"/>
                      <a:pt x="387703" y="1434999"/>
                      <a:pt x="604157" y="1707243"/>
                    </a:cubicBezTo>
                    <a:cubicBezTo>
                      <a:pt x="820611" y="1979487"/>
                      <a:pt x="1237570" y="1889729"/>
                      <a:pt x="1674284" y="1887462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86" name="Freeform 30">
                <a:extLst>
                  <a:ext uri="{FF2B5EF4-FFF2-40B4-BE49-F238E27FC236}">
                    <a16:creationId xmlns:a16="http://schemas.microsoft.com/office/drawing/2014/main" id="{B04068FB-C4A4-C6DA-2C71-8312ADD13FD8}"/>
                  </a:ext>
                </a:extLst>
              </p:cNvPr>
              <p:cNvSpPr/>
              <p:nvPr/>
            </p:nvSpPr>
            <p:spPr>
              <a:xfrm>
                <a:off x="5905815" y="3865944"/>
                <a:ext cx="627514" cy="992031"/>
              </a:xfrm>
              <a:custGeom>
                <a:avLst/>
                <a:gdLst>
                  <a:gd name="connsiteX0" fmla="*/ 0 w 2628053"/>
                  <a:gd name="connsiteY0" fmla="*/ 3294787 h 3665894"/>
                  <a:gd name="connsiteX1" fmla="*/ 778933 w 2628053"/>
                  <a:gd name="connsiteY1" fmla="*/ 3389613 h 3665894"/>
                  <a:gd name="connsiteX2" fmla="*/ 1144693 w 2628053"/>
                  <a:gd name="connsiteY2" fmla="*/ 212920 h 3665894"/>
                  <a:gd name="connsiteX3" fmla="*/ 1320800 w 2628053"/>
                  <a:gd name="connsiteY3" fmla="*/ 422893 h 3665894"/>
                  <a:gd name="connsiteX4" fmla="*/ 1490133 w 2628053"/>
                  <a:gd name="connsiteY4" fmla="*/ 1479533 h 3665894"/>
                  <a:gd name="connsiteX5" fmla="*/ 1551093 w 2628053"/>
                  <a:gd name="connsiteY5" fmla="*/ 1764013 h 3665894"/>
                  <a:gd name="connsiteX6" fmla="*/ 2255520 w 2628053"/>
                  <a:gd name="connsiteY6" fmla="*/ 3172867 h 3665894"/>
                  <a:gd name="connsiteX7" fmla="*/ 2628053 w 2628053"/>
                  <a:gd name="connsiteY7" fmla="*/ 3260920 h 3665894"/>
                  <a:gd name="connsiteX0" fmla="*/ 0 w 2628053"/>
                  <a:gd name="connsiteY0" fmla="*/ 3294787 h 3604646"/>
                  <a:gd name="connsiteX1" fmla="*/ 494453 w 2628053"/>
                  <a:gd name="connsiteY1" fmla="*/ 3315107 h 3604646"/>
                  <a:gd name="connsiteX2" fmla="*/ 778933 w 2628053"/>
                  <a:gd name="connsiteY2" fmla="*/ 3389613 h 3604646"/>
                  <a:gd name="connsiteX3" fmla="*/ 1144693 w 2628053"/>
                  <a:gd name="connsiteY3" fmla="*/ 212920 h 3604646"/>
                  <a:gd name="connsiteX4" fmla="*/ 1320800 w 2628053"/>
                  <a:gd name="connsiteY4" fmla="*/ 422893 h 3604646"/>
                  <a:gd name="connsiteX5" fmla="*/ 1490133 w 2628053"/>
                  <a:gd name="connsiteY5" fmla="*/ 1479533 h 3604646"/>
                  <a:gd name="connsiteX6" fmla="*/ 1551093 w 2628053"/>
                  <a:gd name="connsiteY6" fmla="*/ 1764013 h 3604646"/>
                  <a:gd name="connsiteX7" fmla="*/ 2255520 w 2628053"/>
                  <a:gd name="connsiteY7" fmla="*/ 3172867 h 3604646"/>
                  <a:gd name="connsiteX8" fmla="*/ 2628053 w 2628053"/>
                  <a:gd name="connsiteY8" fmla="*/ 3260920 h 3604646"/>
                  <a:gd name="connsiteX0" fmla="*/ 0 w 2628053"/>
                  <a:gd name="connsiteY0" fmla="*/ 3269778 h 3357961"/>
                  <a:gd name="connsiteX1" fmla="*/ 494453 w 2628053"/>
                  <a:gd name="connsiteY1" fmla="*/ 3290098 h 3357961"/>
                  <a:gd name="connsiteX2" fmla="*/ 866986 w 2628053"/>
                  <a:gd name="connsiteY2" fmla="*/ 3025937 h 3357961"/>
                  <a:gd name="connsiteX3" fmla="*/ 1144693 w 2628053"/>
                  <a:gd name="connsiteY3" fmla="*/ 187911 h 3357961"/>
                  <a:gd name="connsiteX4" fmla="*/ 1320800 w 2628053"/>
                  <a:gd name="connsiteY4" fmla="*/ 397884 h 3357961"/>
                  <a:gd name="connsiteX5" fmla="*/ 1490133 w 2628053"/>
                  <a:gd name="connsiteY5" fmla="*/ 1454524 h 3357961"/>
                  <a:gd name="connsiteX6" fmla="*/ 1551093 w 2628053"/>
                  <a:gd name="connsiteY6" fmla="*/ 1739004 h 3357961"/>
                  <a:gd name="connsiteX7" fmla="*/ 2255520 w 2628053"/>
                  <a:gd name="connsiteY7" fmla="*/ 3147858 h 3357961"/>
                  <a:gd name="connsiteX8" fmla="*/ 2628053 w 2628053"/>
                  <a:gd name="connsiteY8" fmla="*/ 3235911 h 3357961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551093 w 2628053"/>
                  <a:gd name="connsiteY6" fmla="*/ 1739004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3535680"/>
                  <a:gd name="connsiteY0" fmla="*/ 3269778 h 3382815"/>
                  <a:gd name="connsiteX1" fmla="*/ 494453 w 3535680"/>
                  <a:gd name="connsiteY1" fmla="*/ 3290098 h 3382815"/>
                  <a:gd name="connsiteX2" fmla="*/ 866986 w 3535680"/>
                  <a:gd name="connsiteY2" fmla="*/ 3025937 h 3382815"/>
                  <a:gd name="connsiteX3" fmla="*/ 1144693 w 3535680"/>
                  <a:gd name="connsiteY3" fmla="*/ 187911 h 3382815"/>
                  <a:gd name="connsiteX4" fmla="*/ 1320800 w 3535680"/>
                  <a:gd name="connsiteY4" fmla="*/ 397884 h 3382815"/>
                  <a:gd name="connsiteX5" fmla="*/ 1490133 w 3535680"/>
                  <a:gd name="connsiteY5" fmla="*/ 1454524 h 3382815"/>
                  <a:gd name="connsiteX6" fmla="*/ 1645919 w 3535680"/>
                  <a:gd name="connsiteY6" fmla="*/ 2097990 h 3382815"/>
                  <a:gd name="connsiteX7" fmla="*/ 2255520 w 3535680"/>
                  <a:gd name="connsiteY7" fmla="*/ 3147858 h 3382815"/>
                  <a:gd name="connsiteX8" fmla="*/ 3535680 w 3535680"/>
                  <a:gd name="connsiteY8" fmla="*/ 3351057 h 3382815"/>
                  <a:gd name="connsiteX0" fmla="*/ 0 w 3535680"/>
                  <a:gd name="connsiteY0" fmla="*/ 3269778 h 3362942"/>
                  <a:gd name="connsiteX1" fmla="*/ 494453 w 3535680"/>
                  <a:gd name="connsiteY1" fmla="*/ 3290098 h 3362942"/>
                  <a:gd name="connsiteX2" fmla="*/ 866986 w 3535680"/>
                  <a:gd name="connsiteY2" fmla="*/ 3025937 h 3362942"/>
                  <a:gd name="connsiteX3" fmla="*/ 1144693 w 3535680"/>
                  <a:gd name="connsiteY3" fmla="*/ 187911 h 3362942"/>
                  <a:gd name="connsiteX4" fmla="*/ 1320800 w 3535680"/>
                  <a:gd name="connsiteY4" fmla="*/ 397884 h 3362942"/>
                  <a:gd name="connsiteX5" fmla="*/ 1490133 w 3535680"/>
                  <a:gd name="connsiteY5" fmla="*/ 1454524 h 3362942"/>
                  <a:gd name="connsiteX6" fmla="*/ 1645919 w 3535680"/>
                  <a:gd name="connsiteY6" fmla="*/ 2097990 h 3362942"/>
                  <a:gd name="connsiteX7" fmla="*/ 2255520 w 3535680"/>
                  <a:gd name="connsiteY7" fmla="*/ 3147858 h 3362942"/>
                  <a:gd name="connsiteX8" fmla="*/ 3535680 w 3535680"/>
                  <a:gd name="connsiteY8" fmla="*/ 3351057 h 3362942"/>
                  <a:gd name="connsiteX0" fmla="*/ 0 w 3535680"/>
                  <a:gd name="connsiteY0" fmla="*/ 3269778 h 3386908"/>
                  <a:gd name="connsiteX1" fmla="*/ 406400 w 3535680"/>
                  <a:gd name="connsiteY1" fmla="*/ 3337512 h 3386908"/>
                  <a:gd name="connsiteX2" fmla="*/ 866986 w 3535680"/>
                  <a:gd name="connsiteY2" fmla="*/ 3025937 h 3386908"/>
                  <a:gd name="connsiteX3" fmla="*/ 1144693 w 3535680"/>
                  <a:gd name="connsiteY3" fmla="*/ 187911 h 3386908"/>
                  <a:gd name="connsiteX4" fmla="*/ 1320800 w 3535680"/>
                  <a:gd name="connsiteY4" fmla="*/ 397884 h 3386908"/>
                  <a:gd name="connsiteX5" fmla="*/ 1490133 w 3535680"/>
                  <a:gd name="connsiteY5" fmla="*/ 1454524 h 3386908"/>
                  <a:gd name="connsiteX6" fmla="*/ 1645919 w 3535680"/>
                  <a:gd name="connsiteY6" fmla="*/ 2097990 h 3386908"/>
                  <a:gd name="connsiteX7" fmla="*/ 2255520 w 3535680"/>
                  <a:gd name="connsiteY7" fmla="*/ 3147858 h 3386908"/>
                  <a:gd name="connsiteX8" fmla="*/ 3535680 w 3535680"/>
                  <a:gd name="connsiteY8" fmla="*/ 3351057 h 3386908"/>
                  <a:gd name="connsiteX0" fmla="*/ 0 w 3535680"/>
                  <a:gd name="connsiteY0" fmla="*/ 3269778 h 3362216"/>
                  <a:gd name="connsiteX1" fmla="*/ 406400 w 3535680"/>
                  <a:gd name="connsiteY1" fmla="*/ 3337512 h 3362216"/>
                  <a:gd name="connsiteX2" fmla="*/ 866986 w 3535680"/>
                  <a:gd name="connsiteY2" fmla="*/ 3025937 h 3362216"/>
                  <a:gd name="connsiteX3" fmla="*/ 1144693 w 3535680"/>
                  <a:gd name="connsiteY3" fmla="*/ 187911 h 3362216"/>
                  <a:gd name="connsiteX4" fmla="*/ 1320800 w 3535680"/>
                  <a:gd name="connsiteY4" fmla="*/ 397884 h 3362216"/>
                  <a:gd name="connsiteX5" fmla="*/ 1490133 w 3535680"/>
                  <a:gd name="connsiteY5" fmla="*/ 1454524 h 3362216"/>
                  <a:gd name="connsiteX6" fmla="*/ 1645919 w 3535680"/>
                  <a:gd name="connsiteY6" fmla="*/ 2097990 h 3362216"/>
                  <a:gd name="connsiteX7" fmla="*/ 2255520 w 3535680"/>
                  <a:gd name="connsiteY7" fmla="*/ 3147858 h 3362216"/>
                  <a:gd name="connsiteX8" fmla="*/ 3535680 w 3535680"/>
                  <a:gd name="connsiteY8" fmla="*/ 3351057 h 33622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535680" h="3362216">
                    <a:moveTo>
                      <a:pt x="0" y="3269778"/>
                    </a:moveTo>
                    <a:cubicBezTo>
                      <a:pt x="83538" y="3330738"/>
                      <a:pt x="276578" y="3321708"/>
                      <a:pt x="406400" y="3337512"/>
                    </a:cubicBezTo>
                    <a:cubicBezTo>
                      <a:pt x="536222" y="3292356"/>
                      <a:pt x="743937" y="3550870"/>
                      <a:pt x="866986" y="3025937"/>
                    </a:cubicBezTo>
                    <a:cubicBezTo>
                      <a:pt x="990035" y="2501004"/>
                      <a:pt x="1069057" y="625920"/>
                      <a:pt x="1144693" y="187911"/>
                    </a:cubicBezTo>
                    <a:cubicBezTo>
                      <a:pt x="1220329" y="-250098"/>
                      <a:pt x="1263227" y="186782"/>
                      <a:pt x="1320800" y="397884"/>
                    </a:cubicBezTo>
                    <a:cubicBezTo>
                      <a:pt x="1378373" y="608986"/>
                      <a:pt x="1435947" y="1171173"/>
                      <a:pt x="1490133" y="1454524"/>
                    </a:cubicBezTo>
                    <a:cubicBezTo>
                      <a:pt x="1544319" y="1737875"/>
                      <a:pt x="1545449" y="1761581"/>
                      <a:pt x="1645919" y="2097990"/>
                    </a:cubicBezTo>
                    <a:cubicBezTo>
                      <a:pt x="1746389" y="2434399"/>
                      <a:pt x="1940560" y="2939014"/>
                      <a:pt x="2255520" y="3147858"/>
                    </a:cubicBezTo>
                    <a:cubicBezTo>
                      <a:pt x="2570480" y="3356702"/>
                      <a:pt x="3337560" y="3377586"/>
                      <a:pt x="3535680" y="3351057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082B1CF2-F6EC-0442-B453-F0B66CDA6A91}"/>
                  </a:ext>
                </a:extLst>
              </p:cNvPr>
              <p:cNvCxnSpPr/>
              <p:nvPr/>
            </p:nvCxnSpPr>
            <p:spPr>
              <a:xfrm flipV="1">
                <a:off x="1493520" y="1722120"/>
                <a:ext cx="0" cy="352044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>
                <a:extLst>
                  <a:ext uri="{FF2B5EF4-FFF2-40B4-BE49-F238E27FC236}">
                    <a16:creationId xmlns:a16="http://schemas.microsoft.com/office/drawing/2014/main" id="{0EB89BBC-4CA3-CC74-21E6-9D81F2BB75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96986" y="5242560"/>
                <a:ext cx="6793574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1" name="TextBox 38">
              <a:extLst>
                <a:ext uri="{FF2B5EF4-FFF2-40B4-BE49-F238E27FC236}">
                  <a16:creationId xmlns:a16="http://schemas.microsoft.com/office/drawing/2014/main" id="{3BC6CD23-3680-6362-3197-DEF5251259CF}"/>
                </a:ext>
              </a:extLst>
            </p:cNvPr>
            <p:cNvSpPr txBox="1"/>
            <p:nvPr/>
          </p:nvSpPr>
          <p:spPr>
            <a:xfrm rot="16200000">
              <a:off x="-435195" y="3164179"/>
              <a:ext cx="954583" cy="13800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I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39">
              <a:extLst>
                <a:ext uri="{FF2B5EF4-FFF2-40B4-BE49-F238E27FC236}">
                  <a16:creationId xmlns:a16="http://schemas.microsoft.com/office/drawing/2014/main" id="{5DEBA4C8-6B03-9E48-99A7-E389F135F4F5}"/>
                </a:ext>
              </a:extLst>
            </p:cNvPr>
            <p:cNvSpPr txBox="1"/>
            <p:nvPr/>
          </p:nvSpPr>
          <p:spPr>
            <a:xfrm>
              <a:off x="935273" y="4300047"/>
              <a:ext cx="3381550" cy="637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</a:p>
          </p:txBody>
        </p:sp>
      </p:grpSp>
      <p:graphicFrame>
        <p:nvGraphicFramePr>
          <p:cNvPr id="18" name="Table 4">
            <a:extLst>
              <a:ext uri="{FF2B5EF4-FFF2-40B4-BE49-F238E27FC236}">
                <a16:creationId xmlns:a16="http://schemas.microsoft.com/office/drawing/2014/main" id="{20C00FFF-5AE0-9DE7-AA55-ACAE9B0BAB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4076435"/>
              </p:ext>
            </p:extLst>
          </p:nvPr>
        </p:nvGraphicFramePr>
        <p:xfrm>
          <a:off x="95250" y="2654616"/>
          <a:ext cx="3193363" cy="8839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66192">
                  <a:extLst>
                    <a:ext uri="{9D8B030D-6E8A-4147-A177-3AD203B41FA5}">
                      <a16:colId xmlns:a16="http://schemas.microsoft.com/office/drawing/2014/main" val="886443349"/>
                    </a:ext>
                  </a:extLst>
                </a:gridCol>
                <a:gridCol w="631757">
                  <a:extLst>
                    <a:ext uri="{9D8B030D-6E8A-4147-A177-3AD203B41FA5}">
                      <a16:colId xmlns:a16="http://schemas.microsoft.com/office/drawing/2014/main" val="256645292"/>
                    </a:ext>
                  </a:extLst>
                </a:gridCol>
                <a:gridCol w="710727">
                  <a:extLst>
                    <a:ext uri="{9D8B030D-6E8A-4147-A177-3AD203B41FA5}">
                      <a16:colId xmlns:a16="http://schemas.microsoft.com/office/drawing/2014/main" val="1673042616"/>
                    </a:ext>
                  </a:extLst>
                </a:gridCol>
                <a:gridCol w="884687">
                  <a:extLst>
                    <a:ext uri="{9D8B030D-6E8A-4147-A177-3AD203B41FA5}">
                      <a16:colId xmlns:a16="http://schemas.microsoft.com/office/drawing/2014/main" val="3209010362"/>
                    </a:ext>
                  </a:extLst>
                </a:gridCol>
              </a:tblGrid>
              <a:tr h="259080">
                <a:tc>
                  <a:txBody>
                    <a:bodyPr/>
                    <a:lstStyle/>
                    <a:p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37705433"/>
                  </a:ext>
                </a:extLst>
              </a:tr>
              <a:tr h="506200"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phragm neuromuscular functi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spiratory pressure threshold loadin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phragm neuromuscular func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3379148"/>
                  </a:ext>
                </a:extLst>
              </a:tr>
            </a:tbl>
          </a:graphicData>
        </a:graphic>
      </p:graphicFrame>
      <p:sp>
        <p:nvSpPr>
          <p:cNvPr id="107" name="Lightning Bolt 106">
            <a:extLst>
              <a:ext uri="{FF2B5EF4-FFF2-40B4-BE49-F238E27FC236}">
                <a16:creationId xmlns:a16="http://schemas.microsoft.com/office/drawing/2014/main" id="{9407D6F7-D5A3-20C3-F081-01FCE40EBE33}"/>
              </a:ext>
            </a:extLst>
          </p:cNvPr>
          <p:cNvSpPr/>
          <p:nvPr/>
        </p:nvSpPr>
        <p:spPr>
          <a:xfrm rot="1486197">
            <a:off x="395889" y="2352054"/>
            <a:ext cx="97531" cy="97531"/>
          </a:xfrm>
          <a:prstGeom prst="lightningBol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Lightning Bolt 107">
            <a:extLst>
              <a:ext uri="{FF2B5EF4-FFF2-40B4-BE49-F238E27FC236}">
                <a16:creationId xmlns:a16="http://schemas.microsoft.com/office/drawing/2014/main" id="{1848DF71-3FF3-E49C-A0EE-A554FA7BA16F}"/>
              </a:ext>
            </a:extLst>
          </p:cNvPr>
          <p:cNvSpPr/>
          <p:nvPr/>
        </p:nvSpPr>
        <p:spPr>
          <a:xfrm rot="1486197">
            <a:off x="579903" y="2689387"/>
            <a:ext cx="97531" cy="97531"/>
          </a:xfrm>
          <a:prstGeom prst="lightningBol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56A64C6B-D9AE-7605-BFB0-6476361FA471}"/>
              </a:ext>
            </a:extLst>
          </p:cNvPr>
          <p:cNvGrpSpPr/>
          <p:nvPr/>
        </p:nvGrpSpPr>
        <p:grpSpPr>
          <a:xfrm>
            <a:off x="2362094" y="2281060"/>
            <a:ext cx="775317" cy="769281"/>
            <a:chOff x="-647946" y="2660840"/>
            <a:chExt cx="4966505" cy="2276863"/>
          </a:xfrm>
        </p:grpSpPr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4C766C0C-C841-2351-F96A-DCEA3CA904D9}"/>
                </a:ext>
              </a:extLst>
            </p:cNvPr>
            <p:cNvGrpSpPr/>
            <p:nvPr/>
          </p:nvGrpSpPr>
          <p:grpSpPr>
            <a:xfrm>
              <a:off x="935278" y="2660840"/>
              <a:ext cx="3383281" cy="1752331"/>
              <a:chOff x="1493520" y="1722120"/>
              <a:chExt cx="6797040" cy="3520440"/>
            </a:xfrm>
          </p:grpSpPr>
          <p:sp>
            <p:nvSpPr>
              <p:cNvPr id="113" name="Freeform 27">
                <a:extLst>
                  <a:ext uri="{FF2B5EF4-FFF2-40B4-BE49-F238E27FC236}">
                    <a16:creationId xmlns:a16="http://schemas.microsoft.com/office/drawing/2014/main" id="{702E4C8E-7CCF-17D8-416D-5E92AB0EA9CF}"/>
                  </a:ext>
                </a:extLst>
              </p:cNvPr>
              <p:cNvSpPr/>
              <p:nvPr/>
            </p:nvSpPr>
            <p:spPr>
              <a:xfrm>
                <a:off x="3658894" y="2645766"/>
                <a:ext cx="627514" cy="305855"/>
              </a:xfrm>
              <a:custGeom>
                <a:avLst/>
                <a:gdLst>
                  <a:gd name="connsiteX0" fmla="*/ 0 w 2628053"/>
                  <a:gd name="connsiteY0" fmla="*/ 3294787 h 3665894"/>
                  <a:gd name="connsiteX1" fmla="*/ 778933 w 2628053"/>
                  <a:gd name="connsiteY1" fmla="*/ 3389613 h 3665894"/>
                  <a:gd name="connsiteX2" fmla="*/ 1144693 w 2628053"/>
                  <a:gd name="connsiteY2" fmla="*/ 212920 h 3665894"/>
                  <a:gd name="connsiteX3" fmla="*/ 1320800 w 2628053"/>
                  <a:gd name="connsiteY3" fmla="*/ 422893 h 3665894"/>
                  <a:gd name="connsiteX4" fmla="*/ 1490133 w 2628053"/>
                  <a:gd name="connsiteY4" fmla="*/ 1479533 h 3665894"/>
                  <a:gd name="connsiteX5" fmla="*/ 1551093 w 2628053"/>
                  <a:gd name="connsiteY5" fmla="*/ 1764013 h 3665894"/>
                  <a:gd name="connsiteX6" fmla="*/ 2255520 w 2628053"/>
                  <a:gd name="connsiteY6" fmla="*/ 3172867 h 3665894"/>
                  <a:gd name="connsiteX7" fmla="*/ 2628053 w 2628053"/>
                  <a:gd name="connsiteY7" fmla="*/ 3260920 h 3665894"/>
                  <a:gd name="connsiteX0" fmla="*/ 0 w 2628053"/>
                  <a:gd name="connsiteY0" fmla="*/ 3294787 h 3604646"/>
                  <a:gd name="connsiteX1" fmla="*/ 494453 w 2628053"/>
                  <a:gd name="connsiteY1" fmla="*/ 3315107 h 3604646"/>
                  <a:gd name="connsiteX2" fmla="*/ 778933 w 2628053"/>
                  <a:gd name="connsiteY2" fmla="*/ 3389613 h 3604646"/>
                  <a:gd name="connsiteX3" fmla="*/ 1144693 w 2628053"/>
                  <a:gd name="connsiteY3" fmla="*/ 212920 h 3604646"/>
                  <a:gd name="connsiteX4" fmla="*/ 1320800 w 2628053"/>
                  <a:gd name="connsiteY4" fmla="*/ 422893 h 3604646"/>
                  <a:gd name="connsiteX5" fmla="*/ 1490133 w 2628053"/>
                  <a:gd name="connsiteY5" fmla="*/ 1479533 h 3604646"/>
                  <a:gd name="connsiteX6" fmla="*/ 1551093 w 2628053"/>
                  <a:gd name="connsiteY6" fmla="*/ 1764013 h 3604646"/>
                  <a:gd name="connsiteX7" fmla="*/ 2255520 w 2628053"/>
                  <a:gd name="connsiteY7" fmla="*/ 3172867 h 3604646"/>
                  <a:gd name="connsiteX8" fmla="*/ 2628053 w 2628053"/>
                  <a:gd name="connsiteY8" fmla="*/ 3260920 h 3604646"/>
                  <a:gd name="connsiteX0" fmla="*/ 0 w 2628053"/>
                  <a:gd name="connsiteY0" fmla="*/ 3269778 h 3357961"/>
                  <a:gd name="connsiteX1" fmla="*/ 494453 w 2628053"/>
                  <a:gd name="connsiteY1" fmla="*/ 3290098 h 3357961"/>
                  <a:gd name="connsiteX2" fmla="*/ 866986 w 2628053"/>
                  <a:gd name="connsiteY2" fmla="*/ 3025937 h 3357961"/>
                  <a:gd name="connsiteX3" fmla="*/ 1144693 w 2628053"/>
                  <a:gd name="connsiteY3" fmla="*/ 187911 h 3357961"/>
                  <a:gd name="connsiteX4" fmla="*/ 1320800 w 2628053"/>
                  <a:gd name="connsiteY4" fmla="*/ 397884 h 3357961"/>
                  <a:gd name="connsiteX5" fmla="*/ 1490133 w 2628053"/>
                  <a:gd name="connsiteY5" fmla="*/ 1454524 h 3357961"/>
                  <a:gd name="connsiteX6" fmla="*/ 1551093 w 2628053"/>
                  <a:gd name="connsiteY6" fmla="*/ 1739004 h 3357961"/>
                  <a:gd name="connsiteX7" fmla="*/ 2255520 w 2628053"/>
                  <a:gd name="connsiteY7" fmla="*/ 3147858 h 3357961"/>
                  <a:gd name="connsiteX8" fmla="*/ 2628053 w 2628053"/>
                  <a:gd name="connsiteY8" fmla="*/ 3235911 h 3357961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551093 w 2628053"/>
                  <a:gd name="connsiteY6" fmla="*/ 1739004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3535680"/>
                  <a:gd name="connsiteY0" fmla="*/ 3269778 h 3382815"/>
                  <a:gd name="connsiteX1" fmla="*/ 494453 w 3535680"/>
                  <a:gd name="connsiteY1" fmla="*/ 3290098 h 3382815"/>
                  <a:gd name="connsiteX2" fmla="*/ 866986 w 3535680"/>
                  <a:gd name="connsiteY2" fmla="*/ 3025937 h 3382815"/>
                  <a:gd name="connsiteX3" fmla="*/ 1144693 w 3535680"/>
                  <a:gd name="connsiteY3" fmla="*/ 187911 h 3382815"/>
                  <a:gd name="connsiteX4" fmla="*/ 1320800 w 3535680"/>
                  <a:gd name="connsiteY4" fmla="*/ 397884 h 3382815"/>
                  <a:gd name="connsiteX5" fmla="*/ 1490133 w 3535680"/>
                  <a:gd name="connsiteY5" fmla="*/ 1454524 h 3382815"/>
                  <a:gd name="connsiteX6" fmla="*/ 1645919 w 3535680"/>
                  <a:gd name="connsiteY6" fmla="*/ 2097990 h 3382815"/>
                  <a:gd name="connsiteX7" fmla="*/ 2255520 w 3535680"/>
                  <a:gd name="connsiteY7" fmla="*/ 3147858 h 3382815"/>
                  <a:gd name="connsiteX8" fmla="*/ 3535680 w 3535680"/>
                  <a:gd name="connsiteY8" fmla="*/ 3351057 h 3382815"/>
                  <a:gd name="connsiteX0" fmla="*/ 0 w 3535680"/>
                  <a:gd name="connsiteY0" fmla="*/ 3269778 h 3362942"/>
                  <a:gd name="connsiteX1" fmla="*/ 494453 w 3535680"/>
                  <a:gd name="connsiteY1" fmla="*/ 3290098 h 3362942"/>
                  <a:gd name="connsiteX2" fmla="*/ 866986 w 3535680"/>
                  <a:gd name="connsiteY2" fmla="*/ 3025937 h 3362942"/>
                  <a:gd name="connsiteX3" fmla="*/ 1144693 w 3535680"/>
                  <a:gd name="connsiteY3" fmla="*/ 187911 h 3362942"/>
                  <a:gd name="connsiteX4" fmla="*/ 1320800 w 3535680"/>
                  <a:gd name="connsiteY4" fmla="*/ 397884 h 3362942"/>
                  <a:gd name="connsiteX5" fmla="*/ 1490133 w 3535680"/>
                  <a:gd name="connsiteY5" fmla="*/ 1454524 h 3362942"/>
                  <a:gd name="connsiteX6" fmla="*/ 1645919 w 3535680"/>
                  <a:gd name="connsiteY6" fmla="*/ 2097990 h 3362942"/>
                  <a:gd name="connsiteX7" fmla="*/ 2255520 w 3535680"/>
                  <a:gd name="connsiteY7" fmla="*/ 3147858 h 3362942"/>
                  <a:gd name="connsiteX8" fmla="*/ 3535680 w 3535680"/>
                  <a:gd name="connsiteY8" fmla="*/ 3351057 h 3362942"/>
                  <a:gd name="connsiteX0" fmla="*/ 0 w 3535680"/>
                  <a:gd name="connsiteY0" fmla="*/ 3269778 h 3386908"/>
                  <a:gd name="connsiteX1" fmla="*/ 406400 w 3535680"/>
                  <a:gd name="connsiteY1" fmla="*/ 3337512 h 3386908"/>
                  <a:gd name="connsiteX2" fmla="*/ 866986 w 3535680"/>
                  <a:gd name="connsiteY2" fmla="*/ 3025937 h 3386908"/>
                  <a:gd name="connsiteX3" fmla="*/ 1144693 w 3535680"/>
                  <a:gd name="connsiteY3" fmla="*/ 187911 h 3386908"/>
                  <a:gd name="connsiteX4" fmla="*/ 1320800 w 3535680"/>
                  <a:gd name="connsiteY4" fmla="*/ 397884 h 3386908"/>
                  <a:gd name="connsiteX5" fmla="*/ 1490133 w 3535680"/>
                  <a:gd name="connsiteY5" fmla="*/ 1454524 h 3386908"/>
                  <a:gd name="connsiteX6" fmla="*/ 1645919 w 3535680"/>
                  <a:gd name="connsiteY6" fmla="*/ 2097990 h 3386908"/>
                  <a:gd name="connsiteX7" fmla="*/ 2255520 w 3535680"/>
                  <a:gd name="connsiteY7" fmla="*/ 3147858 h 3386908"/>
                  <a:gd name="connsiteX8" fmla="*/ 3535680 w 3535680"/>
                  <a:gd name="connsiteY8" fmla="*/ 3351057 h 3386908"/>
                  <a:gd name="connsiteX0" fmla="*/ 0 w 3535680"/>
                  <a:gd name="connsiteY0" fmla="*/ 3269778 h 3362216"/>
                  <a:gd name="connsiteX1" fmla="*/ 406400 w 3535680"/>
                  <a:gd name="connsiteY1" fmla="*/ 3337512 h 3362216"/>
                  <a:gd name="connsiteX2" fmla="*/ 866986 w 3535680"/>
                  <a:gd name="connsiteY2" fmla="*/ 3025937 h 3362216"/>
                  <a:gd name="connsiteX3" fmla="*/ 1144693 w 3535680"/>
                  <a:gd name="connsiteY3" fmla="*/ 187911 h 3362216"/>
                  <a:gd name="connsiteX4" fmla="*/ 1320800 w 3535680"/>
                  <a:gd name="connsiteY4" fmla="*/ 397884 h 3362216"/>
                  <a:gd name="connsiteX5" fmla="*/ 1490133 w 3535680"/>
                  <a:gd name="connsiteY5" fmla="*/ 1454524 h 3362216"/>
                  <a:gd name="connsiteX6" fmla="*/ 1645919 w 3535680"/>
                  <a:gd name="connsiteY6" fmla="*/ 2097990 h 3362216"/>
                  <a:gd name="connsiteX7" fmla="*/ 2255520 w 3535680"/>
                  <a:gd name="connsiteY7" fmla="*/ 3147858 h 3362216"/>
                  <a:gd name="connsiteX8" fmla="*/ 3535680 w 3535680"/>
                  <a:gd name="connsiteY8" fmla="*/ 3351057 h 33622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535680" h="3362216">
                    <a:moveTo>
                      <a:pt x="0" y="3269778"/>
                    </a:moveTo>
                    <a:cubicBezTo>
                      <a:pt x="83538" y="3330738"/>
                      <a:pt x="276578" y="3321708"/>
                      <a:pt x="406400" y="3337512"/>
                    </a:cubicBezTo>
                    <a:cubicBezTo>
                      <a:pt x="536222" y="3292356"/>
                      <a:pt x="743937" y="3550870"/>
                      <a:pt x="866986" y="3025937"/>
                    </a:cubicBezTo>
                    <a:cubicBezTo>
                      <a:pt x="990035" y="2501004"/>
                      <a:pt x="1069057" y="625920"/>
                      <a:pt x="1144693" y="187911"/>
                    </a:cubicBezTo>
                    <a:cubicBezTo>
                      <a:pt x="1220329" y="-250098"/>
                      <a:pt x="1263227" y="186782"/>
                      <a:pt x="1320800" y="397884"/>
                    </a:cubicBezTo>
                    <a:cubicBezTo>
                      <a:pt x="1378373" y="608986"/>
                      <a:pt x="1435947" y="1171173"/>
                      <a:pt x="1490133" y="1454524"/>
                    </a:cubicBezTo>
                    <a:cubicBezTo>
                      <a:pt x="1544319" y="1737875"/>
                      <a:pt x="1545449" y="1761581"/>
                      <a:pt x="1645919" y="2097990"/>
                    </a:cubicBezTo>
                    <a:cubicBezTo>
                      <a:pt x="1746389" y="2434399"/>
                      <a:pt x="1940560" y="2939014"/>
                      <a:pt x="2255520" y="3147858"/>
                    </a:cubicBezTo>
                    <a:cubicBezTo>
                      <a:pt x="2570480" y="3356702"/>
                      <a:pt x="3337560" y="3377586"/>
                      <a:pt x="3535680" y="3351057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14" name="Freeform 28">
                <a:extLst>
                  <a:ext uri="{FF2B5EF4-FFF2-40B4-BE49-F238E27FC236}">
                    <a16:creationId xmlns:a16="http://schemas.microsoft.com/office/drawing/2014/main" id="{11F54858-5C2A-82AB-C5CB-C8F4725ED948}"/>
                  </a:ext>
                </a:extLst>
              </p:cNvPr>
              <p:cNvSpPr/>
              <p:nvPr/>
            </p:nvSpPr>
            <p:spPr>
              <a:xfrm>
                <a:off x="1822303" y="2937268"/>
                <a:ext cx="1861458" cy="1996493"/>
              </a:xfrm>
              <a:custGeom>
                <a:avLst/>
                <a:gdLst>
                  <a:gd name="connsiteX0" fmla="*/ 1861458 w 1861458"/>
                  <a:gd name="connsiteY0" fmla="*/ 199527 h 2195445"/>
                  <a:gd name="connsiteX1" fmla="*/ 800100 w 1861458"/>
                  <a:gd name="connsiteY1" fmla="*/ 150541 h 2195445"/>
                  <a:gd name="connsiteX2" fmla="*/ 391886 w 1861458"/>
                  <a:gd name="connsiteY2" fmla="*/ 1873205 h 2195445"/>
                  <a:gd name="connsiteX3" fmla="*/ 0 w 1861458"/>
                  <a:gd name="connsiteY3" fmla="*/ 2191612 h 2195445"/>
                  <a:gd name="connsiteX0" fmla="*/ 1861458 w 1861458"/>
                  <a:gd name="connsiteY0" fmla="*/ 44864 h 2038023"/>
                  <a:gd name="connsiteX1" fmla="*/ 644979 w 1861458"/>
                  <a:gd name="connsiteY1" fmla="*/ 477570 h 2038023"/>
                  <a:gd name="connsiteX2" fmla="*/ 391886 w 1861458"/>
                  <a:gd name="connsiteY2" fmla="*/ 1718542 h 2038023"/>
                  <a:gd name="connsiteX3" fmla="*/ 0 w 1861458"/>
                  <a:gd name="connsiteY3" fmla="*/ 2036949 h 2038023"/>
                  <a:gd name="connsiteX0" fmla="*/ 1861458 w 1861458"/>
                  <a:gd name="connsiteY0" fmla="*/ 3334 h 1996493"/>
                  <a:gd name="connsiteX1" fmla="*/ 1004208 w 1861458"/>
                  <a:gd name="connsiteY1" fmla="*/ 35991 h 1996493"/>
                  <a:gd name="connsiteX2" fmla="*/ 644979 w 1861458"/>
                  <a:gd name="connsiteY2" fmla="*/ 436040 h 1996493"/>
                  <a:gd name="connsiteX3" fmla="*/ 391886 w 1861458"/>
                  <a:gd name="connsiteY3" fmla="*/ 1677012 h 1996493"/>
                  <a:gd name="connsiteX4" fmla="*/ 0 w 1861458"/>
                  <a:gd name="connsiteY4" fmla="*/ 1995419 h 19964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861458" h="1996493">
                    <a:moveTo>
                      <a:pt x="1861458" y="3334"/>
                    </a:moveTo>
                    <a:cubicBezTo>
                      <a:pt x="1714501" y="26466"/>
                      <a:pt x="1206955" y="-36127"/>
                      <a:pt x="1004208" y="35991"/>
                    </a:cubicBezTo>
                    <a:cubicBezTo>
                      <a:pt x="801461" y="108109"/>
                      <a:pt x="747033" y="162537"/>
                      <a:pt x="644979" y="436040"/>
                    </a:cubicBezTo>
                    <a:cubicBezTo>
                      <a:pt x="542925" y="709543"/>
                      <a:pt x="499383" y="1417116"/>
                      <a:pt x="391886" y="1677012"/>
                    </a:cubicBezTo>
                    <a:cubicBezTo>
                      <a:pt x="284390" y="1936909"/>
                      <a:pt x="129268" y="2006304"/>
                      <a:pt x="0" y="1995419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15" name="Freeform 29">
                <a:extLst>
                  <a:ext uri="{FF2B5EF4-FFF2-40B4-BE49-F238E27FC236}">
                    <a16:creationId xmlns:a16="http://schemas.microsoft.com/office/drawing/2014/main" id="{291BDE2D-8AFA-E8B3-BDCD-CB57B4E3C4EC}"/>
                  </a:ext>
                </a:extLst>
              </p:cNvPr>
              <p:cNvSpPr/>
              <p:nvPr/>
            </p:nvSpPr>
            <p:spPr>
              <a:xfrm>
                <a:off x="4225645" y="2954564"/>
                <a:ext cx="1674284" cy="1903411"/>
              </a:xfrm>
              <a:custGeom>
                <a:avLst/>
                <a:gdLst>
                  <a:gd name="connsiteX0" fmla="*/ 0 w 1657350"/>
                  <a:gd name="connsiteY0" fmla="*/ 907 h 1913583"/>
                  <a:gd name="connsiteX1" fmla="*/ 138793 w 1657350"/>
                  <a:gd name="connsiteY1" fmla="*/ 9072 h 1913583"/>
                  <a:gd name="connsiteX2" fmla="*/ 269422 w 1657350"/>
                  <a:gd name="connsiteY2" fmla="*/ 66222 h 1913583"/>
                  <a:gd name="connsiteX3" fmla="*/ 375557 w 1657350"/>
                  <a:gd name="connsiteY3" fmla="*/ 254000 h 1913583"/>
                  <a:gd name="connsiteX4" fmla="*/ 604157 w 1657350"/>
                  <a:gd name="connsiteY4" fmla="*/ 1707243 h 1913583"/>
                  <a:gd name="connsiteX5" fmla="*/ 1657350 w 1657350"/>
                  <a:gd name="connsiteY5" fmla="*/ 1870529 h 1913583"/>
                  <a:gd name="connsiteX0" fmla="*/ 0 w 1674284"/>
                  <a:gd name="connsiteY0" fmla="*/ 907 h 1925546"/>
                  <a:gd name="connsiteX1" fmla="*/ 138793 w 1674284"/>
                  <a:gd name="connsiteY1" fmla="*/ 9072 h 1925546"/>
                  <a:gd name="connsiteX2" fmla="*/ 269422 w 1674284"/>
                  <a:gd name="connsiteY2" fmla="*/ 66222 h 1925546"/>
                  <a:gd name="connsiteX3" fmla="*/ 375557 w 1674284"/>
                  <a:gd name="connsiteY3" fmla="*/ 254000 h 1925546"/>
                  <a:gd name="connsiteX4" fmla="*/ 604157 w 1674284"/>
                  <a:gd name="connsiteY4" fmla="*/ 1707243 h 1925546"/>
                  <a:gd name="connsiteX5" fmla="*/ 1674284 w 1674284"/>
                  <a:gd name="connsiteY5" fmla="*/ 1887462 h 1925546"/>
                  <a:gd name="connsiteX0" fmla="*/ 0 w 1674284"/>
                  <a:gd name="connsiteY0" fmla="*/ 907 h 1903411"/>
                  <a:gd name="connsiteX1" fmla="*/ 138793 w 1674284"/>
                  <a:gd name="connsiteY1" fmla="*/ 9072 h 1903411"/>
                  <a:gd name="connsiteX2" fmla="*/ 269422 w 1674284"/>
                  <a:gd name="connsiteY2" fmla="*/ 66222 h 1903411"/>
                  <a:gd name="connsiteX3" fmla="*/ 375557 w 1674284"/>
                  <a:gd name="connsiteY3" fmla="*/ 254000 h 1903411"/>
                  <a:gd name="connsiteX4" fmla="*/ 604157 w 1674284"/>
                  <a:gd name="connsiteY4" fmla="*/ 1707243 h 1903411"/>
                  <a:gd name="connsiteX5" fmla="*/ 1674284 w 1674284"/>
                  <a:gd name="connsiteY5" fmla="*/ 1887462 h 19034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1674284" h="1903411">
                    <a:moveTo>
                      <a:pt x="0" y="907"/>
                    </a:moveTo>
                    <a:cubicBezTo>
                      <a:pt x="46944" y="-454"/>
                      <a:pt x="93889" y="-1814"/>
                      <a:pt x="138793" y="9072"/>
                    </a:cubicBezTo>
                    <a:cubicBezTo>
                      <a:pt x="183697" y="19958"/>
                      <a:pt x="229961" y="25401"/>
                      <a:pt x="269422" y="66222"/>
                    </a:cubicBezTo>
                    <a:cubicBezTo>
                      <a:pt x="308883" y="107043"/>
                      <a:pt x="319768" y="-19504"/>
                      <a:pt x="375557" y="254000"/>
                    </a:cubicBezTo>
                    <a:cubicBezTo>
                      <a:pt x="431346" y="527504"/>
                      <a:pt x="387703" y="1434999"/>
                      <a:pt x="604157" y="1707243"/>
                    </a:cubicBezTo>
                    <a:cubicBezTo>
                      <a:pt x="820611" y="1979487"/>
                      <a:pt x="1237570" y="1889729"/>
                      <a:pt x="1674284" y="1887462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sp>
            <p:nvSpPr>
              <p:cNvPr id="116" name="Freeform 30">
                <a:extLst>
                  <a:ext uri="{FF2B5EF4-FFF2-40B4-BE49-F238E27FC236}">
                    <a16:creationId xmlns:a16="http://schemas.microsoft.com/office/drawing/2014/main" id="{748066B0-4C0D-224A-6317-CC6C22BFFD3A}"/>
                  </a:ext>
                </a:extLst>
              </p:cNvPr>
              <p:cNvSpPr/>
              <p:nvPr/>
            </p:nvSpPr>
            <p:spPr>
              <a:xfrm>
                <a:off x="5905815" y="3865944"/>
                <a:ext cx="627514" cy="992031"/>
              </a:xfrm>
              <a:custGeom>
                <a:avLst/>
                <a:gdLst>
                  <a:gd name="connsiteX0" fmla="*/ 0 w 2628053"/>
                  <a:gd name="connsiteY0" fmla="*/ 3294787 h 3665894"/>
                  <a:gd name="connsiteX1" fmla="*/ 778933 w 2628053"/>
                  <a:gd name="connsiteY1" fmla="*/ 3389613 h 3665894"/>
                  <a:gd name="connsiteX2" fmla="*/ 1144693 w 2628053"/>
                  <a:gd name="connsiteY2" fmla="*/ 212920 h 3665894"/>
                  <a:gd name="connsiteX3" fmla="*/ 1320800 w 2628053"/>
                  <a:gd name="connsiteY3" fmla="*/ 422893 h 3665894"/>
                  <a:gd name="connsiteX4" fmla="*/ 1490133 w 2628053"/>
                  <a:gd name="connsiteY4" fmla="*/ 1479533 h 3665894"/>
                  <a:gd name="connsiteX5" fmla="*/ 1551093 w 2628053"/>
                  <a:gd name="connsiteY5" fmla="*/ 1764013 h 3665894"/>
                  <a:gd name="connsiteX6" fmla="*/ 2255520 w 2628053"/>
                  <a:gd name="connsiteY6" fmla="*/ 3172867 h 3665894"/>
                  <a:gd name="connsiteX7" fmla="*/ 2628053 w 2628053"/>
                  <a:gd name="connsiteY7" fmla="*/ 3260920 h 3665894"/>
                  <a:gd name="connsiteX0" fmla="*/ 0 w 2628053"/>
                  <a:gd name="connsiteY0" fmla="*/ 3294787 h 3604646"/>
                  <a:gd name="connsiteX1" fmla="*/ 494453 w 2628053"/>
                  <a:gd name="connsiteY1" fmla="*/ 3315107 h 3604646"/>
                  <a:gd name="connsiteX2" fmla="*/ 778933 w 2628053"/>
                  <a:gd name="connsiteY2" fmla="*/ 3389613 h 3604646"/>
                  <a:gd name="connsiteX3" fmla="*/ 1144693 w 2628053"/>
                  <a:gd name="connsiteY3" fmla="*/ 212920 h 3604646"/>
                  <a:gd name="connsiteX4" fmla="*/ 1320800 w 2628053"/>
                  <a:gd name="connsiteY4" fmla="*/ 422893 h 3604646"/>
                  <a:gd name="connsiteX5" fmla="*/ 1490133 w 2628053"/>
                  <a:gd name="connsiteY5" fmla="*/ 1479533 h 3604646"/>
                  <a:gd name="connsiteX6" fmla="*/ 1551093 w 2628053"/>
                  <a:gd name="connsiteY6" fmla="*/ 1764013 h 3604646"/>
                  <a:gd name="connsiteX7" fmla="*/ 2255520 w 2628053"/>
                  <a:gd name="connsiteY7" fmla="*/ 3172867 h 3604646"/>
                  <a:gd name="connsiteX8" fmla="*/ 2628053 w 2628053"/>
                  <a:gd name="connsiteY8" fmla="*/ 3260920 h 3604646"/>
                  <a:gd name="connsiteX0" fmla="*/ 0 w 2628053"/>
                  <a:gd name="connsiteY0" fmla="*/ 3269778 h 3357961"/>
                  <a:gd name="connsiteX1" fmla="*/ 494453 w 2628053"/>
                  <a:gd name="connsiteY1" fmla="*/ 3290098 h 3357961"/>
                  <a:gd name="connsiteX2" fmla="*/ 866986 w 2628053"/>
                  <a:gd name="connsiteY2" fmla="*/ 3025937 h 3357961"/>
                  <a:gd name="connsiteX3" fmla="*/ 1144693 w 2628053"/>
                  <a:gd name="connsiteY3" fmla="*/ 187911 h 3357961"/>
                  <a:gd name="connsiteX4" fmla="*/ 1320800 w 2628053"/>
                  <a:gd name="connsiteY4" fmla="*/ 397884 h 3357961"/>
                  <a:gd name="connsiteX5" fmla="*/ 1490133 w 2628053"/>
                  <a:gd name="connsiteY5" fmla="*/ 1454524 h 3357961"/>
                  <a:gd name="connsiteX6" fmla="*/ 1551093 w 2628053"/>
                  <a:gd name="connsiteY6" fmla="*/ 1739004 h 3357961"/>
                  <a:gd name="connsiteX7" fmla="*/ 2255520 w 2628053"/>
                  <a:gd name="connsiteY7" fmla="*/ 3147858 h 3357961"/>
                  <a:gd name="connsiteX8" fmla="*/ 2628053 w 2628053"/>
                  <a:gd name="connsiteY8" fmla="*/ 3235911 h 3357961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551093 w 2628053"/>
                  <a:gd name="connsiteY6" fmla="*/ 1739004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2628053"/>
                  <a:gd name="connsiteY0" fmla="*/ 3269778 h 3362942"/>
                  <a:gd name="connsiteX1" fmla="*/ 494453 w 2628053"/>
                  <a:gd name="connsiteY1" fmla="*/ 3290098 h 3362942"/>
                  <a:gd name="connsiteX2" fmla="*/ 866986 w 2628053"/>
                  <a:gd name="connsiteY2" fmla="*/ 3025937 h 3362942"/>
                  <a:gd name="connsiteX3" fmla="*/ 1144693 w 2628053"/>
                  <a:gd name="connsiteY3" fmla="*/ 187911 h 3362942"/>
                  <a:gd name="connsiteX4" fmla="*/ 1320800 w 2628053"/>
                  <a:gd name="connsiteY4" fmla="*/ 397884 h 3362942"/>
                  <a:gd name="connsiteX5" fmla="*/ 1490133 w 2628053"/>
                  <a:gd name="connsiteY5" fmla="*/ 1454524 h 3362942"/>
                  <a:gd name="connsiteX6" fmla="*/ 1645919 w 2628053"/>
                  <a:gd name="connsiteY6" fmla="*/ 2097990 h 3362942"/>
                  <a:gd name="connsiteX7" fmla="*/ 2255520 w 2628053"/>
                  <a:gd name="connsiteY7" fmla="*/ 3147858 h 3362942"/>
                  <a:gd name="connsiteX8" fmla="*/ 2628053 w 2628053"/>
                  <a:gd name="connsiteY8" fmla="*/ 3235911 h 3362942"/>
                  <a:gd name="connsiteX0" fmla="*/ 0 w 3535680"/>
                  <a:gd name="connsiteY0" fmla="*/ 3269778 h 3382815"/>
                  <a:gd name="connsiteX1" fmla="*/ 494453 w 3535680"/>
                  <a:gd name="connsiteY1" fmla="*/ 3290098 h 3382815"/>
                  <a:gd name="connsiteX2" fmla="*/ 866986 w 3535680"/>
                  <a:gd name="connsiteY2" fmla="*/ 3025937 h 3382815"/>
                  <a:gd name="connsiteX3" fmla="*/ 1144693 w 3535680"/>
                  <a:gd name="connsiteY3" fmla="*/ 187911 h 3382815"/>
                  <a:gd name="connsiteX4" fmla="*/ 1320800 w 3535680"/>
                  <a:gd name="connsiteY4" fmla="*/ 397884 h 3382815"/>
                  <a:gd name="connsiteX5" fmla="*/ 1490133 w 3535680"/>
                  <a:gd name="connsiteY5" fmla="*/ 1454524 h 3382815"/>
                  <a:gd name="connsiteX6" fmla="*/ 1645919 w 3535680"/>
                  <a:gd name="connsiteY6" fmla="*/ 2097990 h 3382815"/>
                  <a:gd name="connsiteX7" fmla="*/ 2255520 w 3535680"/>
                  <a:gd name="connsiteY7" fmla="*/ 3147858 h 3382815"/>
                  <a:gd name="connsiteX8" fmla="*/ 3535680 w 3535680"/>
                  <a:gd name="connsiteY8" fmla="*/ 3351057 h 3382815"/>
                  <a:gd name="connsiteX0" fmla="*/ 0 w 3535680"/>
                  <a:gd name="connsiteY0" fmla="*/ 3269778 h 3362942"/>
                  <a:gd name="connsiteX1" fmla="*/ 494453 w 3535680"/>
                  <a:gd name="connsiteY1" fmla="*/ 3290098 h 3362942"/>
                  <a:gd name="connsiteX2" fmla="*/ 866986 w 3535680"/>
                  <a:gd name="connsiteY2" fmla="*/ 3025937 h 3362942"/>
                  <a:gd name="connsiteX3" fmla="*/ 1144693 w 3535680"/>
                  <a:gd name="connsiteY3" fmla="*/ 187911 h 3362942"/>
                  <a:gd name="connsiteX4" fmla="*/ 1320800 w 3535680"/>
                  <a:gd name="connsiteY4" fmla="*/ 397884 h 3362942"/>
                  <a:gd name="connsiteX5" fmla="*/ 1490133 w 3535680"/>
                  <a:gd name="connsiteY5" fmla="*/ 1454524 h 3362942"/>
                  <a:gd name="connsiteX6" fmla="*/ 1645919 w 3535680"/>
                  <a:gd name="connsiteY6" fmla="*/ 2097990 h 3362942"/>
                  <a:gd name="connsiteX7" fmla="*/ 2255520 w 3535680"/>
                  <a:gd name="connsiteY7" fmla="*/ 3147858 h 3362942"/>
                  <a:gd name="connsiteX8" fmla="*/ 3535680 w 3535680"/>
                  <a:gd name="connsiteY8" fmla="*/ 3351057 h 3362942"/>
                  <a:gd name="connsiteX0" fmla="*/ 0 w 3535680"/>
                  <a:gd name="connsiteY0" fmla="*/ 3269778 h 3386908"/>
                  <a:gd name="connsiteX1" fmla="*/ 406400 w 3535680"/>
                  <a:gd name="connsiteY1" fmla="*/ 3337512 h 3386908"/>
                  <a:gd name="connsiteX2" fmla="*/ 866986 w 3535680"/>
                  <a:gd name="connsiteY2" fmla="*/ 3025937 h 3386908"/>
                  <a:gd name="connsiteX3" fmla="*/ 1144693 w 3535680"/>
                  <a:gd name="connsiteY3" fmla="*/ 187911 h 3386908"/>
                  <a:gd name="connsiteX4" fmla="*/ 1320800 w 3535680"/>
                  <a:gd name="connsiteY4" fmla="*/ 397884 h 3386908"/>
                  <a:gd name="connsiteX5" fmla="*/ 1490133 w 3535680"/>
                  <a:gd name="connsiteY5" fmla="*/ 1454524 h 3386908"/>
                  <a:gd name="connsiteX6" fmla="*/ 1645919 w 3535680"/>
                  <a:gd name="connsiteY6" fmla="*/ 2097990 h 3386908"/>
                  <a:gd name="connsiteX7" fmla="*/ 2255520 w 3535680"/>
                  <a:gd name="connsiteY7" fmla="*/ 3147858 h 3386908"/>
                  <a:gd name="connsiteX8" fmla="*/ 3535680 w 3535680"/>
                  <a:gd name="connsiteY8" fmla="*/ 3351057 h 3386908"/>
                  <a:gd name="connsiteX0" fmla="*/ 0 w 3535680"/>
                  <a:gd name="connsiteY0" fmla="*/ 3269778 h 3362216"/>
                  <a:gd name="connsiteX1" fmla="*/ 406400 w 3535680"/>
                  <a:gd name="connsiteY1" fmla="*/ 3337512 h 3362216"/>
                  <a:gd name="connsiteX2" fmla="*/ 866986 w 3535680"/>
                  <a:gd name="connsiteY2" fmla="*/ 3025937 h 3362216"/>
                  <a:gd name="connsiteX3" fmla="*/ 1144693 w 3535680"/>
                  <a:gd name="connsiteY3" fmla="*/ 187911 h 3362216"/>
                  <a:gd name="connsiteX4" fmla="*/ 1320800 w 3535680"/>
                  <a:gd name="connsiteY4" fmla="*/ 397884 h 3362216"/>
                  <a:gd name="connsiteX5" fmla="*/ 1490133 w 3535680"/>
                  <a:gd name="connsiteY5" fmla="*/ 1454524 h 3362216"/>
                  <a:gd name="connsiteX6" fmla="*/ 1645919 w 3535680"/>
                  <a:gd name="connsiteY6" fmla="*/ 2097990 h 3362216"/>
                  <a:gd name="connsiteX7" fmla="*/ 2255520 w 3535680"/>
                  <a:gd name="connsiteY7" fmla="*/ 3147858 h 3362216"/>
                  <a:gd name="connsiteX8" fmla="*/ 3535680 w 3535680"/>
                  <a:gd name="connsiteY8" fmla="*/ 3351057 h 336221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3535680" h="3362216">
                    <a:moveTo>
                      <a:pt x="0" y="3269778"/>
                    </a:moveTo>
                    <a:cubicBezTo>
                      <a:pt x="83538" y="3330738"/>
                      <a:pt x="276578" y="3321708"/>
                      <a:pt x="406400" y="3337512"/>
                    </a:cubicBezTo>
                    <a:cubicBezTo>
                      <a:pt x="536222" y="3292356"/>
                      <a:pt x="743937" y="3550870"/>
                      <a:pt x="866986" y="3025937"/>
                    </a:cubicBezTo>
                    <a:cubicBezTo>
                      <a:pt x="990035" y="2501004"/>
                      <a:pt x="1069057" y="625920"/>
                      <a:pt x="1144693" y="187911"/>
                    </a:cubicBezTo>
                    <a:cubicBezTo>
                      <a:pt x="1220329" y="-250098"/>
                      <a:pt x="1263227" y="186782"/>
                      <a:pt x="1320800" y="397884"/>
                    </a:cubicBezTo>
                    <a:cubicBezTo>
                      <a:pt x="1378373" y="608986"/>
                      <a:pt x="1435947" y="1171173"/>
                      <a:pt x="1490133" y="1454524"/>
                    </a:cubicBezTo>
                    <a:cubicBezTo>
                      <a:pt x="1544319" y="1737875"/>
                      <a:pt x="1545449" y="1761581"/>
                      <a:pt x="1645919" y="2097990"/>
                    </a:cubicBezTo>
                    <a:cubicBezTo>
                      <a:pt x="1746389" y="2434399"/>
                      <a:pt x="1940560" y="2939014"/>
                      <a:pt x="2255520" y="3147858"/>
                    </a:cubicBezTo>
                    <a:cubicBezTo>
                      <a:pt x="2570480" y="3356702"/>
                      <a:pt x="3337560" y="3377586"/>
                      <a:pt x="3535680" y="3351057"/>
                    </a:cubicBezTo>
                  </a:path>
                </a:pathLst>
              </a:custGeom>
              <a:noFill/>
              <a:ln w="9525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/>
              </a:p>
            </p:txBody>
          </p:sp>
          <p:cxnSp>
            <p:nvCxnSpPr>
              <p:cNvPr id="117" name="Straight Connector 116">
                <a:extLst>
                  <a:ext uri="{FF2B5EF4-FFF2-40B4-BE49-F238E27FC236}">
                    <a16:creationId xmlns:a16="http://schemas.microsoft.com/office/drawing/2014/main" id="{4CC9E11F-820B-7C4A-C2F3-F3C071D92641}"/>
                  </a:ext>
                </a:extLst>
              </p:cNvPr>
              <p:cNvCxnSpPr/>
              <p:nvPr/>
            </p:nvCxnSpPr>
            <p:spPr>
              <a:xfrm flipV="1">
                <a:off x="1493520" y="1722120"/>
                <a:ext cx="0" cy="352044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56CC2DC1-F28A-7CB6-D5D7-4EA1837A91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96986" y="5242560"/>
                <a:ext cx="6793574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TextBox 38">
              <a:extLst>
                <a:ext uri="{FF2B5EF4-FFF2-40B4-BE49-F238E27FC236}">
                  <a16:creationId xmlns:a16="http://schemas.microsoft.com/office/drawing/2014/main" id="{3F2AA1A5-9712-D356-DDEA-01DD8CE60C1C}"/>
                </a:ext>
              </a:extLst>
            </p:cNvPr>
            <p:cNvSpPr txBox="1"/>
            <p:nvPr/>
          </p:nvSpPr>
          <p:spPr>
            <a:xfrm rot="16200000">
              <a:off x="-435195" y="3164179"/>
              <a:ext cx="954583" cy="13800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DI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39">
              <a:extLst>
                <a:ext uri="{FF2B5EF4-FFF2-40B4-BE49-F238E27FC236}">
                  <a16:creationId xmlns:a16="http://schemas.microsoft.com/office/drawing/2014/main" id="{1C2408F8-E33C-6920-DB8C-1D3C75742B53}"/>
                </a:ext>
              </a:extLst>
            </p:cNvPr>
            <p:cNvSpPr txBox="1"/>
            <p:nvPr/>
          </p:nvSpPr>
          <p:spPr>
            <a:xfrm>
              <a:off x="935273" y="4300047"/>
              <a:ext cx="3381550" cy="637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</a:p>
          </p:txBody>
        </p:sp>
      </p:grpSp>
      <p:sp>
        <p:nvSpPr>
          <p:cNvPr id="119" name="Lightning Bolt 118">
            <a:extLst>
              <a:ext uri="{FF2B5EF4-FFF2-40B4-BE49-F238E27FC236}">
                <a16:creationId xmlns:a16="http://schemas.microsoft.com/office/drawing/2014/main" id="{8782E28A-678A-EBF4-2B2B-AE81D1D7C050}"/>
              </a:ext>
            </a:extLst>
          </p:cNvPr>
          <p:cNvSpPr/>
          <p:nvPr/>
        </p:nvSpPr>
        <p:spPr>
          <a:xfrm rot="1486197">
            <a:off x="2696077" y="2362741"/>
            <a:ext cx="97531" cy="97531"/>
          </a:xfrm>
          <a:prstGeom prst="lightningBol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Lightning Bolt 119">
            <a:extLst>
              <a:ext uri="{FF2B5EF4-FFF2-40B4-BE49-F238E27FC236}">
                <a16:creationId xmlns:a16="http://schemas.microsoft.com/office/drawing/2014/main" id="{703113D5-7BE9-240D-8D1F-92E9A3D92856}"/>
              </a:ext>
            </a:extLst>
          </p:cNvPr>
          <p:cNvSpPr/>
          <p:nvPr/>
        </p:nvSpPr>
        <p:spPr>
          <a:xfrm rot="1486197">
            <a:off x="2880091" y="2700074"/>
            <a:ext cx="97531" cy="97531"/>
          </a:xfrm>
          <a:prstGeom prst="lightningBol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353272B4-2001-7602-5E3C-11614FA0114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0903" y="2449805"/>
            <a:ext cx="2011680" cy="2011680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88A6A782-DF9F-44C2-FCCF-F595D0BD46EB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40680" y="2450592"/>
            <a:ext cx="2011680" cy="201168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016F227-4EE8-49F3-1F33-36423B3813AC}"/>
              </a:ext>
            </a:extLst>
          </p:cNvPr>
          <p:cNvSpPr/>
          <p:nvPr/>
        </p:nvSpPr>
        <p:spPr>
          <a:xfrm>
            <a:off x="4217700" y="2441582"/>
            <a:ext cx="740326" cy="7381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C069660-1BF4-C4B3-EA84-8B695A939C71}"/>
              </a:ext>
            </a:extLst>
          </p:cNvPr>
          <p:cNvSpPr/>
          <p:nvPr/>
        </p:nvSpPr>
        <p:spPr>
          <a:xfrm>
            <a:off x="4088605" y="2507424"/>
            <a:ext cx="950796" cy="182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3F0845B-C966-2782-BBD9-6ACC197C0341}"/>
              </a:ext>
            </a:extLst>
          </p:cNvPr>
          <p:cNvSpPr txBox="1"/>
          <p:nvPr/>
        </p:nvSpPr>
        <p:spPr>
          <a:xfrm>
            <a:off x="4219025" y="2238236"/>
            <a:ext cx="7403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0.016</a:t>
            </a:r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7851DA92-2442-C074-3502-0B7A70919788}"/>
              </a:ext>
            </a:extLst>
          </p:cNvPr>
          <p:cNvSpPr/>
          <p:nvPr/>
        </p:nvSpPr>
        <p:spPr>
          <a:xfrm>
            <a:off x="6216651" y="2441582"/>
            <a:ext cx="750812" cy="2242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341E33D-18E6-60D9-B5DC-738222ED366A}"/>
              </a:ext>
            </a:extLst>
          </p:cNvPr>
          <p:cNvSpPr txBox="1"/>
          <p:nvPr/>
        </p:nvSpPr>
        <p:spPr>
          <a:xfrm>
            <a:off x="6216650" y="2248277"/>
            <a:ext cx="7508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= 0.432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F461039-9808-2366-C5A5-C78508F0F98D}"/>
              </a:ext>
            </a:extLst>
          </p:cNvPr>
          <p:cNvSpPr/>
          <p:nvPr/>
        </p:nvSpPr>
        <p:spPr>
          <a:xfrm>
            <a:off x="6128982" y="2631122"/>
            <a:ext cx="950796" cy="530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85614E1-9CC0-85A3-62FC-3B45D3C06E5A}"/>
              </a:ext>
            </a:extLst>
          </p:cNvPr>
          <p:cNvSpPr txBox="1"/>
          <p:nvPr/>
        </p:nvSpPr>
        <p:spPr>
          <a:xfrm>
            <a:off x="3310143" y="2264183"/>
            <a:ext cx="349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CD95A9D-AC63-7053-7C7C-6DB02171E6B8}"/>
              </a:ext>
            </a:extLst>
          </p:cNvPr>
          <p:cNvSpPr txBox="1"/>
          <p:nvPr/>
        </p:nvSpPr>
        <p:spPr>
          <a:xfrm>
            <a:off x="5205998" y="2264183"/>
            <a:ext cx="349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6C48E10-7AA5-F9DA-B28F-9BBE2F80CEA2}"/>
              </a:ext>
            </a:extLst>
          </p:cNvPr>
          <p:cNvSpPr txBox="1"/>
          <p:nvPr/>
        </p:nvSpPr>
        <p:spPr>
          <a:xfrm>
            <a:off x="76197" y="5266305"/>
            <a:ext cx="3193363" cy="924947"/>
          </a:xfrm>
          <a:prstGeom prst="rect">
            <a:avLst/>
          </a:prstGeom>
          <a:noFill/>
        </p:spPr>
        <p:txBody>
          <a:bodyPr wrap="square" lIns="91440" tIns="91440" rIns="91440" bIns="91440" rtlCol="0">
            <a:noAutofit/>
          </a:bodyPr>
          <a:lstStyle/>
          <a:p>
            <a:r>
              <a:rPr lang="en-US" sz="95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phragm neuromuscular function measured with magnetically evoked twitches and maximal inspiratory pressure maneuvers</a:t>
            </a:r>
          </a:p>
          <a:p>
            <a:endParaRPr lang="en-US" sz="300" dirty="0">
              <a:solidFill>
                <a:srgbClr val="00387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50" dirty="0">
                <a:solidFill>
                  <a:srgbClr val="00387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spiratory pressure threshold loading performed until task fail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000" dirty="0">
              <a:solidFill>
                <a:srgbClr val="00387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97962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9</TotalTime>
  <Words>128</Words>
  <Application>Microsoft Office PowerPoint</Application>
  <PresentationFormat>Letter Paper (8.5x11 in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2_Office Theme</vt:lpstr>
      <vt:lpstr>Voluntary activation of the diaphragm after inspiratory pressure threshold loading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uthorized User</dc:creator>
  <cp:keywords/>
  <dc:description/>
  <cp:lastModifiedBy>Ramsook, Andrew H., Ph.D.</cp:lastModifiedBy>
  <cp:revision>34</cp:revision>
  <cp:lastPrinted>2022-10-05T16:44:52Z</cp:lastPrinted>
  <dcterms:created xsi:type="dcterms:W3CDTF">2017-02-21T21:28:19Z</dcterms:created>
  <dcterms:modified xsi:type="dcterms:W3CDTF">2022-10-06T13:34:04Z</dcterms:modified>
  <cp:category/>
</cp:coreProperties>
</file>